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984" autoAdjust="0"/>
    <p:restoredTop sz="94660"/>
  </p:normalViewPr>
  <p:slideViewPr>
    <p:cSldViewPr snapToGrid="0">
      <p:cViewPr varScale="1">
        <p:scale>
          <a:sx n="59" d="100"/>
          <a:sy n="59" d="100"/>
        </p:scale>
        <p:origin x="1644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dsn.dental.upenn.edu\home\homedir\doinaa2\data\data\recombinant%20Abs\replicates%20for%20paper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dsn.dental.upenn.edu\home\homedir\doinaa2\data\data\recombinant%20Abs\replicates%20for%20paper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dsn.dental.upenn.edu\home\homedir\doinaa2\data\data\recombinant%20Abs\replicates%20for%20paper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dsn.dental.upenn.edu\home\homedir\doinaa2\data\data\recombinant%20Abs\replicates%20for%20paper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\\dsn.dental.upenn.edu\home\homedir\doinaa2\data\data\recombinant%20Abs\replicates%20for%20paper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\\dsn.dental.upenn.edu\home\homedir\doinaa2\data\data\recombinant%20Abs\replicates%20for%20paper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MC5/DL11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1!$B$2</c:f>
              <c:strCache>
                <c:ptCount val="1"/>
                <c:pt idx="0">
                  <c:v>MC5</c:v>
                </c:pt>
              </c:strCache>
            </c:strRef>
          </c:tx>
          <c:spPr>
            <a:ln w="28575" cap="rnd">
              <a:solidFill>
                <a:srgbClr val="0000FF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00FF"/>
              </a:solidFill>
              <a:ln w="9525">
                <a:solidFill>
                  <a:srgbClr val="0000FF"/>
                </a:solidFill>
              </a:ln>
              <a:effectLst/>
            </c:spPr>
          </c:marker>
          <c:cat>
            <c:numRef>
              <c:f>Sheet1!$A$3:$A$27</c:f>
              <c:numCache>
                <c:formatCode>General</c:formatCode>
                <c:ptCount val="2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  <c:pt idx="15">
                  <c:v>75</c:v>
                </c:pt>
                <c:pt idx="16">
                  <c:v>80</c:v>
                </c:pt>
                <c:pt idx="17">
                  <c:v>85</c:v>
                </c:pt>
                <c:pt idx="18">
                  <c:v>90</c:v>
                </c:pt>
                <c:pt idx="19">
                  <c:v>95</c:v>
                </c:pt>
                <c:pt idx="20">
                  <c:v>100</c:v>
                </c:pt>
                <c:pt idx="21">
                  <c:v>105</c:v>
                </c:pt>
                <c:pt idx="22">
                  <c:v>110</c:v>
                </c:pt>
                <c:pt idx="23">
                  <c:v>115</c:v>
                </c:pt>
                <c:pt idx="24">
                  <c:v>120</c:v>
                </c:pt>
              </c:numCache>
            </c:numRef>
          </c:cat>
          <c:val>
            <c:numRef>
              <c:f>Sheet1!$B$3:$B$27</c:f>
              <c:numCache>
                <c:formatCode>General</c:formatCode>
                <c:ptCount val="25"/>
                <c:pt idx="0">
                  <c:v>-0.18537380321857813</c:v>
                </c:pt>
                <c:pt idx="1">
                  <c:v>0</c:v>
                </c:pt>
                <c:pt idx="2">
                  <c:v>0.55612140965573442</c:v>
                </c:pt>
                <c:pt idx="3">
                  <c:v>0.84742310042778568</c:v>
                </c:pt>
                <c:pt idx="4">
                  <c:v>2.4098594418415158</c:v>
                </c:pt>
                <c:pt idx="5">
                  <c:v>4.2106335302505604</c:v>
                </c:pt>
                <c:pt idx="6">
                  <c:v>7.6003259319617031</c:v>
                </c:pt>
                <c:pt idx="7">
                  <c:v>8.7655326950499077</c:v>
                </c:pt>
                <c:pt idx="8">
                  <c:v>12.473008759421472</c:v>
                </c:pt>
                <c:pt idx="9">
                  <c:v>12.65838256264005</c:v>
                </c:pt>
                <c:pt idx="10">
                  <c:v>16.524750458341821</c:v>
                </c:pt>
                <c:pt idx="11">
                  <c:v>18.696272153188023</c:v>
                </c:pt>
                <c:pt idx="12">
                  <c:v>21.053167651252807</c:v>
                </c:pt>
                <c:pt idx="13">
                  <c:v>24.416378081075575</c:v>
                </c:pt>
                <c:pt idx="14">
                  <c:v>25.661030759828886</c:v>
                </c:pt>
                <c:pt idx="15">
                  <c:v>30.586677531065391</c:v>
                </c:pt>
                <c:pt idx="16">
                  <c:v>33.367284579344066</c:v>
                </c:pt>
                <c:pt idx="17">
                  <c:v>36.968832756162151</c:v>
                </c:pt>
                <c:pt idx="18">
                  <c:v>40.332043185984929</c:v>
                </c:pt>
                <c:pt idx="19">
                  <c:v>43.801181503361178</c:v>
                </c:pt>
                <c:pt idx="20">
                  <c:v>45.97270319820737</c:v>
                </c:pt>
                <c:pt idx="21">
                  <c:v>51.480953350987974</c:v>
                </c:pt>
                <c:pt idx="22">
                  <c:v>56.750865756773273</c:v>
                </c:pt>
                <c:pt idx="23">
                  <c:v>61.517620696679572</c:v>
                </c:pt>
                <c:pt idx="24">
                  <c:v>66.60215929924628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AAA8-4E76-89A8-DEA7C4257BD0}"/>
            </c:ext>
          </c:extLst>
        </c:ser>
        <c:ser>
          <c:idx val="1"/>
          <c:order val="1"/>
          <c:tx>
            <c:strRef>
              <c:f>Sheet1!$C$2</c:f>
              <c:strCache>
                <c:ptCount val="1"/>
                <c:pt idx="0">
                  <c:v>DL11</c:v>
                </c:pt>
              </c:strCache>
            </c:strRef>
          </c:tx>
          <c:spPr>
            <a:ln w="28575" cap="rnd">
              <a:solidFill>
                <a:srgbClr val="FF00FF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FF"/>
              </a:solidFill>
              <a:ln w="9525">
                <a:solidFill>
                  <a:srgbClr val="FF00FF"/>
                </a:solidFill>
              </a:ln>
              <a:effectLst/>
            </c:spPr>
          </c:marker>
          <c:cat>
            <c:numRef>
              <c:f>Sheet1!$A$3:$A$27</c:f>
              <c:numCache>
                <c:formatCode>General</c:formatCode>
                <c:ptCount val="2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  <c:pt idx="15">
                  <c:v>75</c:v>
                </c:pt>
                <c:pt idx="16">
                  <c:v>80</c:v>
                </c:pt>
                <c:pt idx="17">
                  <c:v>85</c:v>
                </c:pt>
                <c:pt idx="18">
                  <c:v>90</c:v>
                </c:pt>
                <c:pt idx="19">
                  <c:v>95</c:v>
                </c:pt>
                <c:pt idx="20">
                  <c:v>100</c:v>
                </c:pt>
                <c:pt idx="21">
                  <c:v>105</c:v>
                </c:pt>
                <c:pt idx="22">
                  <c:v>110</c:v>
                </c:pt>
                <c:pt idx="23">
                  <c:v>115</c:v>
                </c:pt>
                <c:pt idx="24">
                  <c:v>120</c:v>
                </c:pt>
              </c:numCache>
            </c:numRef>
          </c:cat>
          <c:val>
            <c:numRef>
              <c:f>Sheet1!$C$3:$C$27</c:f>
              <c:numCache>
                <c:formatCode>General</c:formatCode>
                <c:ptCount val="25"/>
                <c:pt idx="0">
                  <c:v>2.8519046649012017E-2</c:v>
                </c:pt>
                <c:pt idx="1">
                  <c:v>-0.1425952332450601</c:v>
                </c:pt>
                <c:pt idx="2">
                  <c:v>-5.7038093298024034E-2</c:v>
                </c:pt>
                <c:pt idx="3">
                  <c:v>0.79853330617233653</c:v>
                </c:pt>
                <c:pt idx="4">
                  <c:v>1.625585658993685</c:v>
                </c:pt>
                <c:pt idx="5">
                  <c:v>2.2815237319209616</c:v>
                </c:pt>
                <c:pt idx="6">
                  <c:v>3.3082094112853939</c:v>
                </c:pt>
                <c:pt idx="7">
                  <c:v>4.7911998370340187</c:v>
                </c:pt>
                <c:pt idx="8">
                  <c:v>7.1867997555510286</c:v>
                </c:pt>
                <c:pt idx="9">
                  <c:v>7.8712568751273162</c:v>
                </c:pt>
                <c:pt idx="10">
                  <c:v>10.209818700346302</c:v>
                </c:pt>
                <c:pt idx="11">
                  <c:v>12.006518639234059</c:v>
                </c:pt>
                <c:pt idx="12">
                  <c:v>13.033204318598489</c:v>
                </c:pt>
                <c:pt idx="13">
                  <c:v>15.913628030148706</c:v>
                </c:pt>
                <c:pt idx="14">
                  <c:v>16.712161336321042</c:v>
                </c:pt>
                <c:pt idx="15">
                  <c:v>19.136280301487062</c:v>
                </c:pt>
                <c:pt idx="16">
                  <c:v>21.531880220004073</c:v>
                </c:pt>
                <c:pt idx="17">
                  <c:v>24.925646771236501</c:v>
                </c:pt>
                <c:pt idx="18">
                  <c:v>27.349765736402521</c:v>
                </c:pt>
                <c:pt idx="19">
                  <c:v>29.631289468323484</c:v>
                </c:pt>
                <c:pt idx="20">
                  <c:v>31.884294153595434</c:v>
                </c:pt>
                <c:pt idx="21">
                  <c:v>34.508046445304544</c:v>
                </c:pt>
                <c:pt idx="22">
                  <c:v>35.648808311265022</c:v>
                </c:pt>
                <c:pt idx="23">
                  <c:v>39.299246282338558</c:v>
                </c:pt>
                <c:pt idx="24">
                  <c:v>43.91933183947850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AAA8-4E76-89A8-DEA7C4257BD0}"/>
            </c:ext>
          </c:extLst>
        </c:ser>
        <c:ser>
          <c:idx val="2"/>
          <c:order val="2"/>
          <c:tx>
            <c:strRef>
              <c:f>Sheet1!$D$2</c:f>
              <c:strCache>
                <c:ptCount val="1"/>
                <c:pt idx="0">
                  <c:v>MC5/DL11</c:v>
                </c:pt>
              </c:strCache>
            </c:strRef>
          </c:tx>
          <c:spPr>
            <a:ln w="28575" cap="rnd">
              <a:solidFill>
                <a:schemeClr val="bg1">
                  <a:lumMod val="6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bg1">
                  <a:lumMod val="65000"/>
                </a:schemeClr>
              </a:solidFill>
              <a:ln w="9525">
                <a:solidFill>
                  <a:schemeClr val="bg1">
                    <a:lumMod val="65000"/>
                  </a:schemeClr>
                </a:solidFill>
              </a:ln>
              <a:effectLst/>
            </c:spPr>
          </c:marker>
          <c:cat>
            <c:numRef>
              <c:f>Sheet1!$A$3:$A$27</c:f>
              <c:numCache>
                <c:formatCode>General</c:formatCode>
                <c:ptCount val="2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  <c:pt idx="15">
                  <c:v>75</c:v>
                </c:pt>
                <c:pt idx="16">
                  <c:v>80</c:v>
                </c:pt>
                <c:pt idx="17">
                  <c:v>85</c:v>
                </c:pt>
                <c:pt idx="18">
                  <c:v>90</c:v>
                </c:pt>
                <c:pt idx="19">
                  <c:v>95</c:v>
                </c:pt>
                <c:pt idx="20">
                  <c:v>100</c:v>
                </c:pt>
                <c:pt idx="21">
                  <c:v>105</c:v>
                </c:pt>
                <c:pt idx="22">
                  <c:v>110</c:v>
                </c:pt>
                <c:pt idx="23">
                  <c:v>115</c:v>
                </c:pt>
                <c:pt idx="24">
                  <c:v>120</c:v>
                </c:pt>
              </c:numCache>
            </c:numRef>
          </c:cat>
          <c:val>
            <c:numRef>
              <c:f>Sheet1!$D$3:$D$27</c:f>
              <c:numCache>
                <c:formatCode>General</c:formatCode>
                <c:ptCount val="25"/>
                <c:pt idx="0">
                  <c:v>8.1482990425748622E-2</c:v>
                </c:pt>
                <c:pt idx="1">
                  <c:v>0.20370747606437159</c:v>
                </c:pt>
                <c:pt idx="2">
                  <c:v>0.40741495212874318</c:v>
                </c:pt>
                <c:pt idx="3">
                  <c:v>1.3444693420248521</c:v>
                </c:pt>
                <c:pt idx="4">
                  <c:v>2.6074556936239559</c:v>
                </c:pt>
                <c:pt idx="5">
                  <c:v>3.5445100835200654</c:v>
                </c:pt>
                <c:pt idx="6">
                  <c:v>7.1705031574658795</c:v>
                </c:pt>
                <c:pt idx="7">
                  <c:v>9.2075779181095943</c:v>
                </c:pt>
                <c:pt idx="8">
                  <c:v>12.466897535139539</c:v>
                </c:pt>
                <c:pt idx="9">
                  <c:v>12.874312487268282</c:v>
                </c:pt>
                <c:pt idx="10">
                  <c:v>16.663271542065594</c:v>
                </c:pt>
                <c:pt idx="11">
                  <c:v>20.126298635159912</c:v>
                </c:pt>
                <c:pt idx="12">
                  <c:v>21.918924424526381</c:v>
                </c:pt>
                <c:pt idx="13">
                  <c:v>26.115298431452434</c:v>
                </c:pt>
                <c:pt idx="14">
                  <c:v>27.337543287838663</c:v>
                </c:pt>
                <c:pt idx="15">
                  <c:v>29.496842534121004</c:v>
                </c:pt>
                <c:pt idx="16">
                  <c:v>33.489509064982684</c:v>
                </c:pt>
                <c:pt idx="17">
                  <c:v>35.485842330413526</c:v>
                </c:pt>
                <c:pt idx="18">
                  <c:v>39.356284375636584</c:v>
                </c:pt>
                <c:pt idx="19">
                  <c:v>45.019352210226117</c:v>
                </c:pt>
                <c:pt idx="20">
                  <c:v>44.734161743735996</c:v>
                </c:pt>
                <c:pt idx="21">
                  <c:v>49.663882664493784</c:v>
                </c:pt>
                <c:pt idx="22">
                  <c:v>55.408433489509065</c:v>
                </c:pt>
                <c:pt idx="23">
                  <c:v>59.889997962925236</c:v>
                </c:pt>
                <c:pt idx="24">
                  <c:v>65.22713383581178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AAA8-4E76-89A8-DEA7C4257BD0}"/>
            </c:ext>
          </c:extLst>
        </c:ser>
        <c:ser>
          <c:idx val="3"/>
          <c:order val="3"/>
          <c:tx>
            <c:strRef>
              <c:f>Sheet1!$E$2</c:f>
              <c:strCache>
                <c:ptCount val="1"/>
                <c:pt idx="0">
                  <c:v>MC5+DL11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numRef>
              <c:f>Sheet1!$A$3:$A$27</c:f>
              <c:numCache>
                <c:formatCode>General</c:formatCode>
                <c:ptCount val="2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  <c:pt idx="15">
                  <c:v>75</c:v>
                </c:pt>
                <c:pt idx="16">
                  <c:v>80</c:v>
                </c:pt>
                <c:pt idx="17">
                  <c:v>85</c:v>
                </c:pt>
                <c:pt idx="18">
                  <c:v>90</c:v>
                </c:pt>
                <c:pt idx="19">
                  <c:v>95</c:v>
                </c:pt>
                <c:pt idx="20">
                  <c:v>100</c:v>
                </c:pt>
                <c:pt idx="21">
                  <c:v>105</c:v>
                </c:pt>
                <c:pt idx="22">
                  <c:v>110</c:v>
                </c:pt>
                <c:pt idx="23">
                  <c:v>115</c:v>
                </c:pt>
                <c:pt idx="24">
                  <c:v>120</c:v>
                </c:pt>
              </c:numCache>
            </c:numRef>
          </c:cat>
          <c:val>
            <c:numRef>
              <c:f>Sheet1!$E$3:$E$27</c:f>
              <c:numCache>
                <c:formatCode>General</c:formatCode>
                <c:ptCount val="25"/>
                <c:pt idx="0">
                  <c:v>-0.24444897127724588</c:v>
                </c:pt>
                <c:pt idx="1">
                  <c:v>0.20370747606437159</c:v>
                </c:pt>
                <c:pt idx="2">
                  <c:v>0.24444897127724588</c:v>
                </c:pt>
                <c:pt idx="3">
                  <c:v>0.5703809329802404</c:v>
                </c:pt>
                <c:pt idx="4">
                  <c:v>1.0592788755347322</c:v>
                </c:pt>
                <c:pt idx="5">
                  <c:v>0.97779588510898352</c:v>
                </c:pt>
                <c:pt idx="6">
                  <c:v>3.5852515787329398</c:v>
                </c:pt>
                <c:pt idx="7">
                  <c:v>5.1741698920350379</c:v>
                </c:pt>
                <c:pt idx="8">
                  <c:v>7.7816255856589942</c:v>
                </c:pt>
                <c:pt idx="9">
                  <c:v>8.352006518639234</c:v>
                </c:pt>
                <c:pt idx="10">
                  <c:v>11.570584640456305</c:v>
                </c:pt>
                <c:pt idx="11">
                  <c:v>14.585455286209005</c:v>
                </c:pt>
                <c:pt idx="12">
                  <c:v>15.644734161743736</c:v>
                </c:pt>
                <c:pt idx="13">
                  <c:v>17.64106742717458</c:v>
                </c:pt>
                <c:pt idx="14">
                  <c:v>20.492972092075778</c:v>
                </c:pt>
                <c:pt idx="15">
                  <c:v>25.544917498472191</c:v>
                </c:pt>
                <c:pt idx="16">
                  <c:v>28.193114687309023</c:v>
                </c:pt>
                <c:pt idx="17">
                  <c:v>30.270930943165613</c:v>
                </c:pt>
                <c:pt idx="18">
                  <c:v>33.285801588918311</c:v>
                </c:pt>
                <c:pt idx="19">
                  <c:v>38.826644937869219</c:v>
                </c:pt>
                <c:pt idx="20">
                  <c:v>43.797107353839884</c:v>
                </c:pt>
                <c:pt idx="21">
                  <c:v>48.441637808107558</c:v>
                </c:pt>
                <c:pt idx="22">
                  <c:v>48.971277245874923</c:v>
                </c:pt>
                <c:pt idx="23">
                  <c:v>55.775106946424934</c:v>
                </c:pt>
                <c:pt idx="24">
                  <c:v>61.92707272356895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AAA8-4E76-89A8-DEA7C4257BD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29451343"/>
        <c:axId val="729460463"/>
      </c:lineChart>
      <c:catAx>
        <c:axId val="72945134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29460463"/>
        <c:crosses val="autoZero"/>
        <c:auto val="1"/>
        <c:lblAlgn val="ctr"/>
        <c:lblOffset val="100"/>
        <c:noMultiLvlLbl val="0"/>
      </c:catAx>
      <c:valAx>
        <c:axId val="729460463"/>
        <c:scaling>
          <c:orientation val="minMax"/>
          <c:max val="10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29451343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MC5/DL11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1!$I$2</c:f>
              <c:strCache>
                <c:ptCount val="1"/>
                <c:pt idx="0">
                  <c:v>MC5</c:v>
                </c:pt>
              </c:strCache>
            </c:strRef>
          </c:tx>
          <c:spPr>
            <a:ln w="28575" cap="rnd">
              <a:solidFill>
                <a:srgbClr val="0000FF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00FF"/>
              </a:solidFill>
              <a:ln w="9525">
                <a:solidFill>
                  <a:srgbClr val="0000FF"/>
                </a:solidFill>
              </a:ln>
              <a:effectLst/>
            </c:spPr>
          </c:marker>
          <c:cat>
            <c:numRef>
              <c:f>Sheet1!$H$3:$H$27</c:f>
              <c:numCache>
                <c:formatCode>General</c:formatCode>
                <c:ptCount val="2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  <c:pt idx="15">
                  <c:v>75</c:v>
                </c:pt>
                <c:pt idx="16">
                  <c:v>80</c:v>
                </c:pt>
                <c:pt idx="17">
                  <c:v>85</c:v>
                </c:pt>
                <c:pt idx="18">
                  <c:v>90</c:v>
                </c:pt>
                <c:pt idx="19">
                  <c:v>95</c:v>
                </c:pt>
                <c:pt idx="20">
                  <c:v>100</c:v>
                </c:pt>
                <c:pt idx="21">
                  <c:v>105</c:v>
                </c:pt>
                <c:pt idx="22">
                  <c:v>110</c:v>
                </c:pt>
                <c:pt idx="23">
                  <c:v>115</c:v>
                </c:pt>
                <c:pt idx="24">
                  <c:v>120</c:v>
                </c:pt>
              </c:numCache>
            </c:numRef>
          </c:cat>
          <c:val>
            <c:numRef>
              <c:f>Sheet1!$I$3:$I$27</c:f>
              <c:numCache>
                <c:formatCode>General</c:formatCode>
                <c:ptCount val="25"/>
                <c:pt idx="0">
                  <c:v>-4.5071318999999999E-2</c:v>
                </c:pt>
                <c:pt idx="1">
                  <c:v>0</c:v>
                </c:pt>
                <c:pt idx="2">
                  <c:v>8.4840129E-2</c:v>
                </c:pt>
                <c:pt idx="3">
                  <c:v>1.0101277900000001</c:v>
                </c:pt>
                <c:pt idx="4">
                  <c:v>2.6698128209999998</c:v>
                </c:pt>
                <c:pt idx="5">
                  <c:v>5.4377220429999999</c:v>
                </c:pt>
                <c:pt idx="6">
                  <c:v>8.0863248320000007</c:v>
                </c:pt>
                <c:pt idx="7">
                  <c:v>10.99475052</c:v>
                </c:pt>
                <c:pt idx="8">
                  <c:v>14.025133889999999</c:v>
                </c:pt>
                <c:pt idx="9">
                  <c:v>17.376318999999999</c:v>
                </c:pt>
                <c:pt idx="10">
                  <c:v>20.897184370000002</c:v>
                </c:pt>
                <c:pt idx="11">
                  <c:v>24.396839709999998</c:v>
                </c:pt>
                <c:pt idx="12">
                  <c:v>28.235855560000001</c:v>
                </c:pt>
                <c:pt idx="13">
                  <c:v>31.669229550000001</c:v>
                </c:pt>
                <c:pt idx="14">
                  <c:v>35.516199159999999</c:v>
                </c:pt>
                <c:pt idx="15">
                  <c:v>39.376425050000002</c:v>
                </c:pt>
                <c:pt idx="16">
                  <c:v>43.576011450000003</c:v>
                </c:pt>
                <c:pt idx="17">
                  <c:v>48.724746809999999</c:v>
                </c:pt>
                <c:pt idx="18">
                  <c:v>51.79755024</c:v>
                </c:pt>
                <c:pt idx="19">
                  <c:v>55.795641340000003</c:v>
                </c:pt>
                <c:pt idx="20">
                  <c:v>61.000053029999997</c:v>
                </c:pt>
                <c:pt idx="21">
                  <c:v>65.045866689999997</c:v>
                </c:pt>
                <c:pt idx="22">
                  <c:v>68.789437399999997</c:v>
                </c:pt>
                <c:pt idx="23">
                  <c:v>72.920091200000002</c:v>
                </c:pt>
                <c:pt idx="24">
                  <c:v>79.18765575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43EA-4803-B977-4557B64A52D2}"/>
            </c:ext>
          </c:extLst>
        </c:ser>
        <c:ser>
          <c:idx val="1"/>
          <c:order val="1"/>
          <c:tx>
            <c:strRef>
              <c:f>Sheet1!$J$2</c:f>
              <c:strCache>
                <c:ptCount val="1"/>
                <c:pt idx="0">
                  <c:v>DL11</c:v>
                </c:pt>
              </c:strCache>
            </c:strRef>
          </c:tx>
          <c:spPr>
            <a:ln w="28575" cap="rnd">
              <a:solidFill>
                <a:srgbClr val="FF00FF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FF"/>
              </a:solidFill>
              <a:ln w="9525">
                <a:solidFill>
                  <a:srgbClr val="FF00FF"/>
                </a:solidFill>
              </a:ln>
              <a:effectLst/>
            </c:spPr>
          </c:marker>
          <c:cat>
            <c:numRef>
              <c:f>Sheet1!$H$3:$H$27</c:f>
              <c:numCache>
                <c:formatCode>General</c:formatCode>
                <c:ptCount val="2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  <c:pt idx="15">
                  <c:v>75</c:v>
                </c:pt>
                <c:pt idx="16">
                  <c:v>80</c:v>
                </c:pt>
                <c:pt idx="17">
                  <c:v>85</c:v>
                </c:pt>
                <c:pt idx="18">
                  <c:v>90</c:v>
                </c:pt>
                <c:pt idx="19">
                  <c:v>95</c:v>
                </c:pt>
                <c:pt idx="20">
                  <c:v>100</c:v>
                </c:pt>
                <c:pt idx="21">
                  <c:v>105</c:v>
                </c:pt>
                <c:pt idx="22">
                  <c:v>110</c:v>
                </c:pt>
                <c:pt idx="23">
                  <c:v>115</c:v>
                </c:pt>
                <c:pt idx="24">
                  <c:v>120</c:v>
                </c:pt>
              </c:numCache>
            </c:numRef>
          </c:cat>
          <c:val>
            <c:numRef>
              <c:f>Sheet1!$J$3:$J$27</c:f>
              <c:numCache>
                <c:formatCode>General</c:formatCode>
                <c:ptCount val="25"/>
                <c:pt idx="0">
                  <c:v>-6.6273931999999994E-2</c:v>
                </c:pt>
                <c:pt idx="1">
                  <c:v>-3.9273440999999999E-2</c:v>
                </c:pt>
                <c:pt idx="2">
                  <c:v>6.3819342000000001E-2</c:v>
                </c:pt>
                <c:pt idx="3">
                  <c:v>0.32646048100000002</c:v>
                </c:pt>
                <c:pt idx="4">
                  <c:v>1.200294551</c:v>
                </c:pt>
                <c:pt idx="5">
                  <c:v>2.0397643589999999</c:v>
                </c:pt>
                <c:pt idx="6">
                  <c:v>3.9666175749999999</c:v>
                </c:pt>
                <c:pt idx="7">
                  <c:v>5.4810996559999996</c:v>
                </c:pt>
                <c:pt idx="8">
                  <c:v>7.0888561609999998</c:v>
                </c:pt>
                <c:pt idx="9">
                  <c:v>8.8659793810000007</c:v>
                </c:pt>
                <c:pt idx="10">
                  <c:v>11.099656360000001</c:v>
                </c:pt>
                <c:pt idx="11">
                  <c:v>12.66077565</c:v>
                </c:pt>
                <c:pt idx="12">
                  <c:v>14.801178200000001</c:v>
                </c:pt>
                <c:pt idx="13">
                  <c:v>17.017673049999999</c:v>
                </c:pt>
                <c:pt idx="14">
                  <c:v>20.05891016</c:v>
                </c:pt>
                <c:pt idx="15">
                  <c:v>22.076583209999999</c:v>
                </c:pt>
                <c:pt idx="16">
                  <c:v>24.231713299999999</c:v>
                </c:pt>
                <c:pt idx="17">
                  <c:v>26.578301419999999</c:v>
                </c:pt>
                <c:pt idx="18">
                  <c:v>28.96661757</c:v>
                </c:pt>
                <c:pt idx="19">
                  <c:v>31.426116839999999</c:v>
                </c:pt>
                <c:pt idx="20">
                  <c:v>33.834069710000001</c:v>
                </c:pt>
                <c:pt idx="21">
                  <c:v>36.647029949999997</c:v>
                </c:pt>
                <c:pt idx="22">
                  <c:v>39.793814429999998</c:v>
                </c:pt>
                <c:pt idx="23">
                  <c:v>41.89494354</c:v>
                </c:pt>
                <c:pt idx="24">
                  <c:v>45.3166421199999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43EA-4803-B977-4557B64A52D2}"/>
            </c:ext>
          </c:extLst>
        </c:ser>
        <c:ser>
          <c:idx val="2"/>
          <c:order val="2"/>
          <c:tx>
            <c:strRef>
              <c:f>Sheet1!$K$2</c:f>
              <c:strCache>
                <c:ptCount val="1"/>
                <c:pt idx="0">
                  <c:v>MC5/DL11</c:v>
                </c:pt>
              </c:strCache>
            </c:strRef>
          </c:tx>
          <c:spPr>
            <a:ln w="28575" cap="rnd">
              <a:solidFill>
                <a:schemeClr val="bg1">
                  <a:lumMod val="6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bg1">
                  <a:lumMod val="65000"/>
                </a:schemeClr>
              </a:solidFill>
              <a:ln w="9525">
                <a:solidFill>
                  <a:schemeClr val="bg1">
                    <a:lumMod val="65000"/>
                  </a:schemeClr>
                </a:solidFill>
              </a:ln>
              <a:effectLst/>
            </c:spPr>
          </c:marker>
          <c:cat>
            <c:numRef>
              <c:f>Sheet1!$H$3:$H$27</c:f>
              <c:numCache>
                <c:formatCode>General</c:formatCode>
                <c:ptCount val="2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  <c:pt idx="15">
                  <c:v>75</c:v>
                </c:pt>
                <c:pt idx="16">
                  <c:v>80</c:v>
                </c:pt>
                <c:pt idx="17">
                  <c:v>85</c:v>
                </c:pt>
                <c:pt idx="18">
                  <c:v>90</c:v>
                </c:pt>
                <c:pt idx="19">
                  <c:v>95</c:v>
                </c:pt>
                <c:pt idx="20">
                  <c:v>100</c:v>
                </c:pt>
                <c:pt idx="21">
                  <c:v>105</c:v>
                </c:pt>
                <c:pt idx="22">
                  <c:v>110</c:v>
                </c:pt>
                <c:pt idx="23">
                  <c:v>115</c:v>
                </c:pt>
                <c:pt idx="24">
                  <c:v>120</c:v>
                </c:pt>
              </c:numCache>
            </c:numRef>
          </c:cat>
          <c:val>
            <c:numRef>
              <c:f>Sheet1!$K$3:$K$27</c:f>
              <c:numCache>
                <c:formatCode>General</c:formatCode>
                <c:ptCount val="25"/>
                <c:pt idx="0">
                  <c:v>-5.0712387999999997E-2</c:v>
                </c:pt>
                <c:pt idx="1">
                  <c:v>0</c:v>
                </c:pt>
                <c:pt idx="2">
                  <c:v>0.106254528</c:v>
                </c:pt>
                <c:pt idx="3">
                  <c:v>0.87659985500000004</c:v>
                </c:pt>
                <c:pt idx="4">
                  <c:v>2.2096112049999999</c:v>
                </c:pt>
                <c:pt idx="5">
                  <c:v>4.2477662399999998</c:v>
                </c:pt>
                <c:pt idx="6">
                  <c:v>6.0033808259999999</c:v>
                </c:pt>
                <c:pt idx="7">
                  <c:v>8.0970779999999998</c:v>
                </c:pt>
                <c:pt idx="8">
                  <c:v>9.9299686069999993</c:v>
                </c:pt>
                <c:pt idx="9">
                  <c:v>12.68292683</c:v>
                </c:pt>
                <c:pt idx="10">
                  <c:v>14.885293409999999</c:v>
                </c:pt>
                <c:pt idx="11">
                  <c:v>17.594783870000001</c:v>
                </c:pt>
                <c:pt idx="12">
                  <c:v>19.893745469999999</c:v>
                </c:pt>
                <c:pt idx="13">
                  <c:v>23.214199470000001</c:v>
                </c:pt>
                <c:pt idx="14">
                  <c:v>26.795460030000001</c:v>
                </c:pt>
                <c:pt idx="15">
                  <c:v>28.630765520000001</c:v>
                </c:pt>
                <c:pt idx="16">
                  <c:v>31.14223617</c:v>
                </c:pt>
                <c:pt idx="17">
                  <c:v>34.730741369999997</c:v>
                </c:pt>
                <c:pt idx="18">
                  <c:v>37.452306210000003</c:v>
                </c:pt>
                <c:pt idx="19">
                  <c:v>40.586814779999997</c:v>
                </c:pt>
                <c:pt idx="20">
                  <c:v>44.221202609999999</c:v>
                </c:pt>
                <c:pt idx="21">
                  <c:v>46.36078242</c:v>
                </c:pt>
                <c:pt idx="22">
                  <c:v>50.548176769999998</c:v>
                </c:pt>
                <c:pt idx="23">
                  <c:v>54.465105049999998</c:v>
                </c:pt>
                <c:pt idx="24">
                  <c:v>58.21782178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43EA-4803-B977-4557B64A52D2}"/>
            </c:ext>
          </c:extLst>
        </c:ser>
        <c:ser>
          <c:idx val="3"/>
          <c:order val="3"/>
          <c:tx>
            <c:strRef>
              <c:f>Sheet1!$L$2</c:f>
              <c:strCache>
                <c:ptCount val="1"/>
                <c:pt idx="0">
                  <c:v>MC5+DL11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numRef>
              <c:f>Sheet1!$H$3:$H$27</c:f>
              <c:numCache>
                <c:formatCode>General</c:formatCode>
                <c:ptCount val="2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  <c:pt idx="15">
                  <c:v>75</c:v>
                </c:pt>
                <c:pt idx="16">
                  <c:v>80</c:v>
                </c:pt>
                <c:pt idx="17">
                  <c:v>85</c:v>
                </c:pt>
                <c:pt idx="18">
                  <c:v>90</c:v>
                </c:pt>
                <c:pt idx="19">
                  <c:v>95</c:v>
                </c:pt>
                <c:pt idx="20">
                  <c:v>100</c:v>
                </c:pt>
                <c:pt idx="21">
                  <c:v>105</c:v>
                </c:pt>
                <c:pt idx="22">
                  <c:v>110</c:v>
                </c:pt>
                <c:pt idx="23">
                  <c:v>115</c:v>
                </c:pt>
                <c:pt idx="24">
                  <c:v>120</c:v>
                </c:pt>
              </c:numCache>
            </c:numRef>
          </c:cat>
          <c:val>
            <c:numRef>
              <c:f>Sheet1!$L$3:$L$27</c:f>
              <c:numCache>
                <c:formatCode>General</c:formatCode>
                <c:ptCount val="25"/>
                <c:pt idx="0">
                  <c:v>-2.6414651000000001E-2</c:v>
                </c:pt>
                <c:pt idx="1">
                  <c:v>5.869923E-3</c:v>
                </c:pt>
                <c:pt idx="2">
                  <c:v>0.14674806300000001</c:v>
                </c:pt>
                <c:pt idx="3">
                  <c:v>0.613406903</c:v>
                </c:pt>
                <c:pt idx="4">
                  <c:v>1.8519605539999999</c:v>
                </c:pt>
                <c:pt idx="5">
                  <c:v>3.507278704</c:v>
                </c:pt>
                <c:pt idx="6">
                  <c:v>5.7349142989999997</c:v>
                </c:pt>
                <c:pt idx="7">
                  <c:v>8.4380136179999994</c:v>
                </c:pt>
                <c:pt idx="8">
                  <c:v>11.223291850000001</c:v>
                </c:pt>
                <c:pt idx="9">
                  <c:v>14.099553889999999</c:v>
                </c:pt>
                <c:pt idx="10">
                  <c:v>17.55106833</c:v>
                </c:pt>
                <c:pt idx="11">
                  <c:v>19.91077718</c:v>
                </c:pt>
                <c:pt idx="12">
                  <c:v>24.019722940000001</c:v>
                </c:pt>
                <c:pt idx="13">
                  <c:v>26.31779761</c:v>
                </c:pt>
                <c:pt idx="14">
                  <c:v>30.382718950000001</c:v>
                </c:pt>
                <c:pt idx="15">
                  <c:v>33.804883779999997</c:v>
                </c:pt>
                <c:pt idx="16">
                  <c:v>37.573374029999997</c:v>
                </c:pt>
                <c:pt idx="17">
                  <c:v>42.292791739999998</c:v>
                </c:pt>
                <c:pt idx="18">
                  <c:v>45.594623149999997</c:v>
                </c:pt>
                <c:pt idx="19">
                  <c:v>50.37274008</c:v>
                </c:pt>
                <c:pt idx="20">
                  <c:v>54.390702040000001</c:v>
                </c:pt>
                <c:pt idx="21">
                  <c:v>58.417468890000002</c:v>
                </c:pt>
                <c:pt idx="22">
                  <c:v>62.814040849999998</c:v>
                </c:pt>
                <c:pt idx="23">
                  <c:v>65.813571260000003</c:v>
                </c:pt>
                <c:pt idx="24">
                  <c:v>71.4017374999999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43EA-4803-B977-4557B64A52D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19998607"/>
        <c:axId val="719999087"/>
      </c:lineChart>
      <c:catAx>
        <c:axId val="71999860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19999087"/>
        <c:crosses val="autoZero"/>
        <c:auto val="1"/>
        <c:lblAlgn val="ctr"/>
        <c:lblOffset val="100"/>
        <c:noMultiLvlLbl val="0"/>
      </c:catAx>
      <c:valAx>
        <c:axId val="719999087"/>
        <c:scaling>
          <c:orientation val="minMax"/>
          <c:max val="10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19998607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MC2/DL11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2!$B$1</c:f>
              <c:strCache>
                <c:ptCount val="1"/>
                <c:pt idx="0">
                  <c:v>MC2</c:v>
                </c:pt>
              </c:strCache>
            </c:strRef>
          </c:tx>
          <c:spPr>
            <a:ln w="28575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cat>
            <c:numRef>
              <c:f>Sheet2!$A$2:$A$26</c:f>
              <c:numCache>
                <c:formatCode>General</c:formatCode>
                <c:ptCount val="2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  <c:pt idx="15">
                  <c:v>75</c:v>
                </c:pt>
                <c:pt idx="16">
                  <c:v>80</c:v>
                </c:pt>
                <c:pt idx="17">
                  <c:v>85</c:v>
                </c:pt>
                <c:pt idx="18">
                  <c:v>90</c:v>
                </c:pt>
                <c:pt idx="19">
                  <c:v>95</c:v>
                </c:pt>
                <c:pt idx="20">
                  <c:v>100</c:v>
                </c:pt>
                <c:pt idx="21">
                  <c:v>105</c:v>
                </c:pt>
                <c:pt idx="22">
                  <c:v>110</c:v>
                </c:pt>
                <c:pt idx="23">
                  <c:v>115</c:v>
                </c:pt>
                <c:pt idx="24">
                  <c:v>120</c:v>
                </c:pt>
              </c:numCache>
            </c:numRef>
          </c:cat>
          <c:val>
            <c:numRef>
              <c:f>Sheet2!$B$2:$B$26</c:f>
              <c:numCache>
                <c:formatCode>General</c:formatCode>
                <c:ptCount val="25"/>
                <c:pt idx="0">
                  <c:v>-9.4741828517290377E-2</c:v>
                </c:pt>
                <c:pt idx="1">
                  <c:v>-0.11842728564661298</c:v>
                </c:pt>
                <c:pt idx="2">
                  <c:v>0.11842728564661298</c:v>
                </c:pt>
                <c:pt idx="3">
                  <c:v>0.90004737091425868</c:v>
                </c:pt>
                <c:pt idx="4">
                  <c:v>1.8711511132164851</c:v>
                </c:pt>
                <c:pt idx="5">
                  <c:v>3.7423022264329702</c:v>
                </c:pt>
                <c:pt idx="6">
                  <c:v>5.5897678825201327</c:v>
                </c:pt>
                <c:pt idx="7">
                  <c:v>7.8398863098057792</c:v>
                </c:pt>
                <c:pt idx="8">
                  <c:v>9.4741828517290383</c:v>
                </c:pt>
                <c:pt idx="9">
                  <c:v>12.387494078635717</c:v>
                </c:pt>
                <c:pt idx="10">
                  <c:v>15.371861676930365</c:v>
                </c:pt>
                <c:pt idx="11">
                  <c:v>16.745618190431074</c:v>
                </c:pt>
                <c:pt idx="12">
                  <c:v>18.711511132164851</c:v>
                </c:pt>
                <c:pt idx="13">
                  <c:v>22.572240644244435</c:v>
                </c:pt>
                <c:pt idx="14">
                  <c:v>24.680246328754144</c:v>
                </c:pt>
                <c:pt idx="15">
                  <c:v>27.238275698720987</c:v>
                </c:pt>
                <c:pt idx="16">
                  <c:v>30.104216011369019</c:v>
                </c:pt>
                <c:pt idx="17">
                  <c:v>33.183325438180958</c:v>
                </c:pt>
                <c:pt idx="18">
                  <c:v>36.19137849360493</c:v>
                </c:pt>
                <c:pt idx="19">
                  <c:v>38.038844149692089</c:v>
                </c:pt>
                <c:pt idx="20">
                  <c:v>41.75746091899574</c:v>
                </c:pt>
                <c:pt idx="21">
                  <c:v>42.444339175746094</c:v>
                </c:pt>
                <c:pt idx="22">
                  <c:v>47.347228801515868</c:v>
                </c:pt>
                <c:pt idx="23">
                  <c:v>50.35528185693984</c:v>
                </c:pt>
                <c:pt idx="24">
                  <c:v>54.42918048318332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D0B-4049-B313-A484D8496B46}"/>
            </c:ext>
          </c:extLst>
        </c:ser>
        <c:ser>
          <c:idx val="1"/>
          <c:order val="1"/>
          <c:tx>
            <c:strRef>
              <c:f>Sheet2!$C$1</c:f>
              <c:strCache>
                <c:ptCount val="1"/>
                <c:pt idx="0">
                  <c:v>DL11</c:v>
                </c:pt>
              </c:strCache>
            </c:strRef>
          </c:tx>
          <c:spPr>
            <a:ln w="28575" cap="rnd">
              <a:solidFill>
                <a:srgbClr val="FF00FF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FF"/>
              </a:solidFill>
              <a:ln w="9525">
                <a:solidFill>
                  <a:srgbClr val="FF00FF"/>
                </a:solidFill>
              </a:ln>
              <a:effectLst/>
            </c:spPr>
          </c:marker>
          <c:cat>
            <c:numRef>
              <c:f>Sheet2!$A$2:$A$26</c:f>
              <c:numCache>
                <c:formatCode>General</c:formatCode>
                <c:ptCount val="2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  <c:pt idx="15">
                  <c:v>75</c:v>
                </c:pt>
                <c:pt idx="16">
                  <c:v>80</c:v>
                </c:pt>
                <c:pt idx="17">
                  <c:v>85</c:v>
                </c:pt>
                <c:pt idx="18">
                  <c:v>90</c:v>
                </c:pt>
                <c:pt idx="19">
                  <c:v>95</c:v>
                </c:pt>
                <c:pt idx="20">
                  <c:v>100</c:v>
                </c:pt>
                <c:pt idx="21">
                  <c:v>105</c:v>
                </c:pt>
                <c:pt idx="22">
                  <c:v>110</c:v>
                </c:pt>
                <c:pt idx="23">
                  <c:v>115</c:v>
                </c:pt>
                <c:pt idx="24">
                  <c:v>120</c:v>
                </c:pt>
              </c:numCache>
            </c:numRef>
          </c:cat>
          <c:val>
            <c:numRef>
              <c:f>Sheet2!$C$2:$C$26</c:f>
              <c:numCache>
                <c:formatCode>General</c:formatCode>
                <c:ptCount val="25"/>
                <c:pt idx="0">
                  <c:v>7.105637138796779E-2</c:v>
                </c:pt>
                <c:pt idx="1">
                  <c:v>-0.16579819990525818</c:v>
                </c:pt>
                <c:pt idx="2">
                  <c:v>2.3685457129322594E-2</c:v>
                </c:pt>
                <c:pt idx="3">
                  <c:v>0.33159639981051636</c:v>
                </c:pt>
                <c:pt idx="4">
                  <c:v>1.1132164850781621</c:v>
                </c:pt>
                <c:pt idx="5">
                  <c:v>2.4396020843202275</c:v>
                </c:pt>
                <c:pt idx="6">
                  <c:v>4.1212695405021318</c:v>
                </c:pt>
                <c:pt idx="7">
                  <c:v>5.092373282804358</c:v>
                </c:pt>
                <c:pt idx="8">
                  <c:v>6.6319279962103268</c:v>
                </c:pt>
                <c:pt idx="9">
                  <c:v>9.3557555660824256</c:v>
                </c:pt>
                <c:pt idx="10">
                  <c:v>10.705826622453813</c:v>
                </c:pt>
                <c:pt idx="11">
                  <c:v>12.387494078635717</c:v>
                </c:pt>
                <c:pt idx="12">
                  <c:v>13.95073424917101</c:v>
                </c:pt>
                <c:pt idx="13">
                  <c:v>15.513974419706301</c:v>
                </c:pt>
                <c:pt idx="14">
                  <c:v>18.758882046423494</c:v>
                </c:pt>
                <c:pt idx="15">
                  <c:v>21.056371387967786</c:v>
                </c:pt>
                <c:pt idx="16">
                  <c:v>22.169587873045948</c:v>
                </c:pt>
                <c:pt idx="17">
                  <c:v>25.911890099478921</c:v>
                </c:pt>
                <c:pt idx="18">
                  <c:v>26.456655613453339</c:v>
                </c:pt>
                <c:pt idx="19">
                  <c:v>29.156797726196114</c:v>
                </c:pt>
                <c:pt idx="20">
                  <c:v>31.477972524869731</c:v>
                </c:pt>
                <c:pt idx="21">
                  <c:v>32.780672666982476</c:v>
                </c:pt>
                <c:pt idx="22">
                  <c:v>35.83609663666509</c:v>
                </c:pt>
                <c:pt idx="23">
                  <c:v>38.749407863571768</c:v>
                </c:pt>
                <c:pt idx="24">
                  <c:v>41.402179062055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DD0B-4049-B313-A484D8496B46}"/>
            </c:ext>
          </c:extLst>
        </c:ser>
        <c:ser>
          <c:idx val="2"/>
          <c:order val="2"/>
          <c:tx>
            <c:strRef>
              <c:f>Sheet2!$D$1</c:f>
              <c:strCache>
                <c:ptCount val="1"/>
                <c:pt idx="0">
                  <c:v>MC2+DL11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numRef>
              <c:f>Sheet2!$A$2:$A$26</c:f>
              <c:numCache>
                <c:formatCode>General</c:formatCode>
                <c:ptCount val="2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  <c:pt idx="15">
                  <c:v>75</c:v>
                </c:pt>
                <c:pt idx="16">
                  <c:v>80</c:v>
                </c:pt>
                <c:pt idx="17">
                  <c:v>85</c:v>
                </c:pt>
                <c:pt idx="18">
                  <c:v>90</c:v>
                </c:pt>
                <c:pt idx="19">
                  <c:v>95</c:v>
                </c:pt>
                <c:pt idx="20">
                  <c:v>100</c:v>
                </c:pt>
                <c:pt idx="21">
                  <c:v>105</c:v>
                </c:pt>
                <c:pt idx="22">
                  <c:v>110</c:v>
                </c:pt>
                <c:pt idx="23">
                  <c:v>115</c:v>
                </c:pt>
                <c:pt idx="24">
                  <c:v>120</c:v>
                </c:pt>
              </c:numCache>
            </c:numRef>
          </c:cat>
          <c:val>
            <c:numRef>
              <c:f>Sheet2!$D$2:$D$26</c:f>
              <c:numCache>
                <c:formatCode>General</c:formatCode>
                <c:ptCount val="25"/>
                <c:pt idx="0">
                  <c:v>-9.4741828517290377E-2</c:v>
                </c:pt>
                <c:pt idx="1">
                  <c:v>-2.3685457129322594E-2</c:v>
                </c:pt>
                <c:pt idx="2">
                  <c:v>1.451E-3</c:v>
                </c:pt>
                <c:pt idx="3">
                  <c:v>1.519E-2</c:v>
                </c:pt>
                <c:pt idx="4">
                  <c:v>4.0550000000000003E-2</c:v>
                </c:pt>
                <c:pt idx="5">
                  <c:v>4.7370914258645189E-2</c:v>
                </c:pt>
                <c:pt idx="6">
                  <c:v>0.23685457129322596</c:v>
                </c:pt>
                <c:pt idx="7">
                  <c:v>0.47370914258645191</c:v>
                </c:pt>
                <c:pt idx="8">
                  <c:v>0.73424917100900045</c:v>
                </c:pt>
                <c:pt idx="9">
                  <c:v>1.989578398863098</c:v>
                </c:pt>
                <c:pt idx="10">
                  <c:v>2.1553765987683562</c:v>
                </c:pt>
                <c:pt idx="11">
                  <c:v>3.1501657981999052</c:v>
                </c:pt>
                <c:pt idx="12">
                  <c:v>4.6423495973472289</c:v>
                </c:pt>
                <c:pt idx="13">
                  <c:v>5.5423969682614871</c:v>
                </c:pt>
                <c:pt idx="14">
                  <c:v>7.8162008526764568</c:v>
                </c:pt>
                <c:pt idx="15">
                  <c:v>8.7636191378493606</c:v>
                </c:pt>
                <c:pt idx="16">
                  <c:v>10.303173851255329</c:v>
                </c:pt>
                <c:pt idx="17">
                  <c:v>11.440075793462814</c:v>
                </c:pt>
                <c:pt idx="18">
                  <c:v>12.387494078635717</c:v>
                </c:pt>
                <c:pt idx="19">
                  <c:v>15.845570819516817</c:v>
                </c:pt>
                <c:pt idx="20">
                  <c:v>16.271909047844623</c:v>
                </c:pt>
                <c:pt idx="21">
                  <c:v>19.587873045949788</c:v>
                </c:pt>
                <c:pt idx="22">
                  <c:v>21.601136901942208</c:v>
                </c:pt>
                <c:pt idx="23">
                  <c:v>22.027475130270012</c:v>
                </c:pt>
                <c:pt idx="24">
                  <c:v>24.72761724301279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DD0B-4049-B313-A484D8496B46}"/>
            </c:ext>
          </c:extLst>
        </c:ser>
        <c:ser>
          <c:idx val="3"/>
          <c:order val="3"/>
          <c:tx>
            <c:strRef>
              <c:f>Sheet2!$E$1</c:f>
              <c:strCache>
                <c:ptCount val="1"/>
                <c:pt idx="0">
                  <c:v>MC2/DL11</c:v>
                </c:pt>
              </c:strCache>
            </c:strRef>
          </c:tx>
          <c:spPr>
            <a:ln w="28575" cap="rnd">
              <a:solidFill>
                <a:schemeClr val="bg1">
                  <a:lumMod val="6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bg1">
                  <a:lumMod val="65000"/>
                </a:schemeClr>
              </a:solidFill>
              <a:ln w="9525">
                <a:solidFill>
                  <a:schemeClr val="bg1">
                    <a:lumMod val="65000"/>
                  </a:schemeClr>
                </a:solidFill>
              </a:ln>
              <a:effectLst/>
            </c:spPr>
          </c:marker>
          <c:cat>
            <c:numRef>
              <c:f>Sheet2!$A$2:$A$26</c:f>
              <c:numCache>
                <c:formatCode>General</c:formatCode>
                <c:ptCount val="2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  <c:pt idx="15">
                  <c:v>75</c:v>
                </c:pt>
                <c:pt idx="16">
                  <c:v>80</c:v>
                </c:pt>
                <c:pt idx="17">
                  <c:v>85</c:v>
                </c:pt>
                <c:pt idx="18">
                  <c:v>90</c:v>
                </c:pt>
                <c:pt idx="19">
                  <c:v>95</c:v>
                </c:pt>
                <c:pt idx="20">
                  <c:v>100</c:v>
                </c:pt>
                <c:pt idx="21">
                  <c:v>105</c:v>
                </c:pt>
                <c:pt idx="22">
                  <c:v>110</c:v>
                </c:pt>
                <c:pt idx="23">
                  <c:v>115</c:v>
                </c:pt>
                <c:pt idx="24">
                  <c:v>120</c:v>
                </c:pt>
              </c:numCache>
            </c:numRef>
          </c:cat>
          <c:val>
            <c:numRef>
              <c:f>Sheet2!$E$2:$E$26</c:f>
              <c:numCache>
                <c:formatCode>General</c:formatCode>
                <c:ptCount val="25"/>
                <c:pt idx="0">
                  <c:v>2.3685457129322594E-2</c:v>
                </c:pt>
                <c:pt idx="1">
                  <c:v>4.7370914258645189E-2</c:v>
                </c:pt>
                <c:pt idx="2">
                  <c:v>0.30791094268119373</c:v>
                </c:pt>
                <c:pt idx="3">
                  <c:v>0.26054002842254853</c:v>
                </c:pt>
                <c:pt idx="4">
                  <c:v>1.1369019422074846</c:v>
                </c:pt>
                <c:pt idx="5">
                  <c:v>3.3159639981051634</c:v>
                </c:pt>
                <c:pt idx="6">
                  <c:v>4.3107531975367124</c:v>
                </c:pt>
                <c:pt idx="7">
                  <c:v>7.5082899099952627</c:v>
                </c:pt>
                <c:pt idx="8">
                  <c:v>8.7399336807200374</c:v>
                </c:pt>
                <c:pt idx="9">
                  <c:v>11.961155850307911</c:v>
                </c:pt>
                <c:pt idx="10">
                  <c:v>14.069161534817622</c:v>
                </c:pt>
                <c:pt idx="11">
                  <c:v>17.053529133112271</c:v>
                </c:pt>
                <c:pt idx="12">
                  <c:v>19.422074846044527</c:v>
                </c:pt>
                <c:pt idx="13">
                  <c:v>22.738038844149692</c:v>
                </c:pt>
                <c:pt idx="14">
                  <c:v>25.864519185220274</c:v>
                </c:pt>
                <c:pt idx="15">
                  <c:v>29.417337754618664</c:v>
                </c:pt>
                <c:pt idx="16">
                  <c:v>32.662245381335858</c:v>
                </c:pt>
                <c:pt idx="17">
                  <c:v>35.291331122690671</c:v>
                </c:pt>
                <c:pt idx="18">
                  <c:v>38.417811463761254</c:v>
                </c:pt>
                <c:pt idx="19">
                  <c:v>43.439128375177638</c:v>
                </c:pt>
                <c:pt idx="20">
                  <c:v>44.883941260066322</c:v>
                </c:pt>
                <c:pt idx="21">
                  <c:v>49.076267171956417</c:v>
                </c:pt>
                <c:pt idx="22">
                  <c:v>54.831833254381813</c:v>
                </c:pt>
                <c:pt idx="23">
                  <c:v>56.300331596399808</c:v>
                </c:pt>
                <c:pt idx="24">
                  <c:v>59.3320701089531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DD0B-4049-B313-A484D8496B4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48841231"/>
        <c:axId val="848840751"/>
      </c:lineChart>
      <c:catAx>
        <c:axId val="84884123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48840751"/>
        <c:crosses val="autoZero"/>
        <c:auto val="1"/>
        <c:lblAlgn val="ctr"/>
        <c:lblOffset val="100"/>
        <c:noMultiLvlLbl val="0"/>
      </c:catAx>
      <c:valAx>
        <c:axId val="848840751"/>
        <c:scaling>
          <c:orientation val="minMax"/>
          <c:max val="10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48841231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MC2/DL11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2!$P$30</c:f>
              <c:strCache>
                <c:ptCount val="1"/>
                <c:pt idx="0">
                  <c:v>MC2</c:v>
                </c:pt>
              </c:strCache>
            </c:strRef>
          </c:tx>
          <c:spPr>
            <a:ln w="28575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cat>
            <c:numRef>
              <c:f>Sheet2!$O$31:$O$55</c:f>
              <c:numCache>
                <c:formatCode>General</c:formatCode>
                <c:ptCount val="2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  <c:pt idx="15">
                  <c:v>75</c:v>
                </c:pt>
                <c:pt idx="16">
                  <c:v>80</c:v>
                </c:pt>
                <c:pt idx="17">
                  <c:v>85</c:v>
                </c:pt>
                <c:pt idx="18">
                  <c:v>90</c:v>
                </c:pt>
                <c:pt idx="19">
                  <c:v>95</c:v>
                </c:pt>
                <c:pt idx="20">
                  <c:v>100</c:v>
                </c:pt>
                <c:pt idx="21">
                  <c:v>105</c:v>
                </c:pt>
                <c:pt idx="22">
                  <c:v>110</c:v>
                </c:pt>
                <c:pt idx="23">
                  <c:v>115</c:v>
                </c:pt>
                <c:pt idx="24">
                  <c:v>120</c:v>
                </c:pt>
              </c:numCache>
            </c:numRef>
          </c:cat>
          <c:val>
            <c:numRef>
              <c:f>Sheet2!$P$31:$P$55</c:f>
              <c:numCache>
                <c:formatCode>General</c:formatCode>
                <c:ptCount val="25"/>
                <c:pt idx="0">
                  <c:v>0.65464711704266021</c:v>
                </c:pt>
                <c:pt idx="1">
                  <c:v>0.85376554735886212</c:v>
                </c:pt>
                <c:pt idx="2">
                  <c:v>1.6757986674421215</c:v>
                </c:pt>
                <c:pt idx="3">
                  <c:v>2.6907771893844314</c:v>
                </c:pt>
                <c:pt idx="4">
                  <c:v>4.2358198904159909</c:v>
                </c:pt>
                <c:pt idx="5">
                  <c:v>5.9005479200465274</c:v>
                </c:pt>
                <c:pt idx="6">
                  <c:v>8.1176854714459168</c:v>
                </c:pt>
                <c:pt idx="7">
                  <c:v>9.575846623200384</c:v>
                </c:pt>
                <c:pt idx="8">
                  <c:v>12.153111512442988</c:v>
                </c:pt>
                <c:pt idx="9">
                  <c:v>14.70099074555899</c:v>
                </c:pt>
                <c:pt idx="10">
                  <c:v>16.140173661065027</c:v>
                </c:pt>
                <c:pt idx="11">
                  <c:v>17.848572040772599</c:v>
                </c:pt>
                <c:pt idx="12">
                  <c:v>21.518973134572022</c:v>
                </c:pt>
                <c:pt idx="13">
                  <c:v>23.20604650688216</c:v>
                </c:pt>
                <c:pt idx="14">
                  <c:v>25.52883977675064</c:v>
                </c:pt>
                <c:pt idx="15">
                  <c:v>28.178089320150601</c:v>
                </c:pt>
                <c:pt idx="16">
                  <c:v>30.410582917546705</c:v>
                </c:pt>
                <c:pt idx="17">
                  <c:v>33.510871672431563</c:v>
                </c:pt>
                <c:pt idx="18">
                  <c:v>35.36619833277215</c:v>
                </c:pt>
                <c:pt idx="19">
                  <c:v>38.709479935106678</c:v>
                </c:pt>
                <c:pt idx="20">
                  <c:v>38.709479935106678</c:v>
                </c:pt>
                <c:pt idx="21">
                  <c:v>39.164600487720264</c:v>
                </c:pt>
                <c:pt idx="22">
                  <c:v>43.556939810421703</c:v>
                </c:pt>
                <c:pt idx="23">
                  <c:v>45.939575744589675</c:v>
                </c:pt>
                <c:pt idx="24">
                  <c:v>49.81929862152703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F50-4047-AF11-8182496C9BE0}"/>
            </c:ext>
          </c:extLst>
        </c:ser>
        <c:ser>
          <c:idx val="1"/>
          <c:order val="1"/>
          <c:tx>
            <c:strRef>
              <c:f>Sheet2!$Q$30</c:f>
              <c:strCache>
                <c:ptCount val="1"/>
                <c:pt idx="0">
                  <c:v>DL11</c:v>
                </c:pt>
              </c:strCache>
            </c:strRef>
          </c:tx>
          <c:spPr>
            <a:ln w="28575" cap="rnd">
              <a:solidFill>
                <a:srgbClr val="FF00FF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FF"/>
              </a:solidFill>
              <a:ln w="9525">
                <a:solidFill>
                  <a:srgbClr val="FF00FF"/>
                </a:solidFill>
              </a:ln>
              <a:effectLst/>
            </c:spPr>
          </c:marker>
          <c:cat>
            <c:numRef>
              <c:f>Sheet2!$O$31:$O$55</c:f>
              <c:numCache>
                <c:formatCode>General</c:formatCode>
                <c:ptCount val="2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  <c:pt idx="15">
                  <c:v>75</c:v>
                </c:pt>
                <c:pt idx="16">
                  <c:v>80</c:v>
                </c:pt>
                <c:pt idx="17">
                  <c:v>85</c:v>
                </c:pt>
                <c:pt idx="18">
                  <c:v>90</c:v>
                </c:pt>
                <c:pt idx="19">
                  <c:v>95</c:v>
                </c:pt>
                <c:pt idx="20">
                  <c:v>100</c:v>
                </c:pt>
                <c:pt idx="21">
                  <c:v>105</c:v>
                </c:pt>
                <c:pt idx="22">
                  <c:v>110</c:v>
                </c:pt>
                <c:pt idx="23">
                  <c:v>115</c:v>
                </c:pt>
                <c:pt idx="24">
                  <c:v>120</c:v>
                </c:pt>
              </c:numCache>
            </c:numRef>
          </c:cat>
          <c:val>
            <c:numRef>
              <c:f>Sheet2!$Q$31:$Q$55</c:f>
              <c:numCache>
                <c:formatCode>General</c:formatCode>
                <c:ptCount val="25"/>
                <c:pt idx="0">
                  <c:v>0.6180170804126236</c:v>
                </c:pt>
                <c:pt idx="1">
                  <c:v>0.76091503668105331</c:v>
                </c:pt>
                <c:pt idx="2">
                  <c:v>1.1774669156284756</c:v>
                </c:pt>
                <c:pt idx="3">
                  <c:v>2.0263348536329038</c:v>
                </c:pt>
                <c:pt idx="4">
                  <c:v>3.1109512585835706</c:v>
                </c:pt>
                <c:pt idx="5">
                  <c:v>4.6082932851735077</c:v>
                </c:pt>
                <c:pt idx="6">
                  <c:v>5.606232207903517</c:v>
                </c:pt>
                <c:pt idx="7">
                  <c:v>6.6478567857397941</c:v>
                </c:pt>
                <c:pt idx="8">
                  <c:v>8.4806493413735566</c:v>
                </c:pt>
                <c:pt idx="9">
                  <c:v>9.5737855459303702</c:v>
                </c:pt>
                <c:pt idx="10">
                  <c:v>11.162906731151836</c:v>
                </c:pt>
                <c:pt idx="11">
                  <c:v>13.153004377238364</c:v>
                </c:pt>
                <c:pt idx="12">
                  <c:v>14.306865836113751</c:v>
                </c:pt>
                <c:pt idx="13">
                  <c:v>16.382855306253646</c:v>
                </c:pt>
                <c:pt idx="14">
                  <c:v>18.253961451733016</c:v>
                </c:pt>
                <c:pt idx="15">
                  <c:v>20.278531125327785</c:v>
                </c:pt>
                <c:pt idx="16">
                  <c:v>22.749135265848381</c:v>
                </c:pt>
                <c:pt idx="17">
                  <c:v>24.45979878988237</c:v>
                </c:pt>
                <c:pt idx="18">
                  <c:v>25.763425061475186</c:v>
                </c:pt>
                <c:pt idx="19">
                  <c:v>27.207775975185449</c:v>
                </c:pt>
                <c:pt idx="20">
                  <c:v>28.207775975185449</c:v>
                </c:pt>
                <c:pt idx="21">
                  <c:v>30.722346363014903</c:v>
                </c:pt>
                <c:pt idx="22">
                  <c:v>31.156728601018312</c:v>
                </c:pt>
                <c:pt idx="23">
                  <c:v>33.926923587090727</c:v>
                </c:pt>
                <c:pt idx="24">
                  <c:v>36.79144857000010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F50-4047-AF11-8182496C9BE0}"/>
            </c:ext>
          </c:extLst>
        </c:ser>
        <c:ser>
          <c:idx val="2"/>
          <c:order val="2"/>
          <c:tx>
            <c:strRef>
              <c:f>Sheet2!$R$30</c:f>
              <c:strCache>
                <c:ptCount val="1"/>
                <c:pt idx="0">
                  <c:v>MC2+DL11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numRef>
              <c:f>Sheet2!$O$31:$O$55</c:f>
              <c:numCache>
                <c:formatCode>General</c:formatCode>
                <c:ptCount val="2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  <c:pt idx="15">
                  <c:v>75</c:v>
                </c:pt>
                <c:pt idx="16">
                  <c:v>80</c:v>
                </c:pt>
                <c:pt idx="17">
                  <c:v>85</c:v>
                </c:pt>
                <c:pt idx="18">
                  <c:v>90</c:v>
                </c:pt>
                <c:pt idx="19">
                  <c:v>95</c:v>
                </c:pt>
                <c:pt idx="20">
                  <c:v>100</c:v>
                </c:pt>
                <c:pt idx="21">
                  <c:v>105</c:v>
                </c:pt>
                <c:pt idx="22">
                  <c:v>110</c:v>
                </c:pt>
                <c:pt idx="23">
                  <c:v>115</c:v>
                </c:pt>
                <c:pt idx="24">
                  <c:v>120</c:v>
                </c:pt>
              </c:numCache>
            </c:numRef>
          </c:cat>
          <c:val>
            <c:numRef>
              <c:f>Sheet2!$R$31:$R$55</c:f>
              <c:numCache>
                <c:formatCode>General</c:formatCode>
                <c:ptCount val="25"/>
                <c:pt idx="0">
                  <c:v>0.74749762772046902</c:v>
                </c:pt>
                <c:pt idx="1">
                  <c:v>0.77923005499607179</c:v>
                </c:pt>
                <c:pt idx="2">
                  <c:v>1.0895140143051005</c:v>
                </c:pt>
                <c:pt idx="3">
                  <c:v>1.428979562684298</c:v>
                </c:pt>
                <c:pt idx="4">
                  <c:v>1.5571846908894265</c:v>
                </c:pt>
                <c:pt idx="5">
                  <c:v>2.7836277000622403</c:v>
                </c:pt>
                <c:pt idx="6">
                  <c:v>3.0119277194486109</c:v>
                </c:pt>
                <c:pt idx="7">
                  <c:v>3.9951738141153186</c:v>
                </c:pt>
                <c:pt idx="8">
                  <c:v>4.7776332302794691</c:v>
                </c:pt>
                <c:pt idx="9">
                  <c:v>5.4346271184711288</c:v>
                </c:pt>
                <c:pt idx="10">
                  <c:v>7.3591835277072022</c:v>
                </c:pt>
                <c:pt idx="11">
                  <c:v>7.4465548379197388</c:v>
                </c:pt>
                <c:pt idx="12">
                  <c:v>9.9498658259104147</c:v>
                </c:pt>
                <c:pt idx="13">
                  <c:v>10.670528635709672</c:v>
                </c:pt>
                <c:pt idx="14">
                  <c:v>11.698924566612567</c:v>
                </c:pt>
                <c:pt idx="15">
                  <c:v>13.962773067229906</c:v>
                </c:pt>
                <c:pt idx="16">
                  <c:v>14.796254349179129</c:v>
                </c:pt>
                <c:pt idx="17">
                  <c:v>17.031788545716132</c:v>
                </c:pt>
                <c:pt idx="18">
                  <c:v>18.912470537818734</c:v>
                </c:pt>
                <c:pt idx="19">
                  <c:v>20.254486924403345</c:v>
                </c:pt>
                <c:pt idx="20">
                  <c:v>20.754486924403345</c:v>
                </c:pt>
                <c:pt idx="21">
                  <c:v>23.226759313110289</c:v>
                </c:pt>
                <c:pt idx="22">
                  <c:v>24.482179844296837</c:v>
                </c:pt>
                <c:pt idx="23">
                  <c:v>27.119083330782495</c:v>
                </c:pt>
                <c:pt idx="24">
                  <c:v>28.789009968675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5F50-4047-AF11-8182496C9BE0}"/>
            </c:ext>
          </c:extLst>
        </c:ser>
        <c:ser>
          <c:idx val="3"/>
          <c:order val="3"/>
          <c:tx>
            <c:strRef>
              <c:f>Sheet2!$S$30</c:f>
              <c:strCache>
                <c:ptCount val="1"/>
                <c:pt idx="0">
                  <c:v>MC2/DL11</c:v>
                </c:pt>
              </c:strCache>
            </c:strRef>
          </c:tx>
          <c:spPr>
            <a:ln w="28575" cap="rnd">
              <a:solidFill>
                <a:schemeClr val="bg1">
                  <a:lumMod val="6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bg1">
                  <a:lumMod val="65000"/>
                </a:schemeClr>
              </a:solidFill>
              <a:ln w="9525">
                <a:solidFill>
                  <a:schemeClr val="bg1">
                    <a:lumMod val="65000"/>
                  </a:schemeClr>
                </a:solidFill>
              </a:ln>
              <a:effectLst/>
            </c:spPr>
          </c:marker>
          <c:cat>
            <c:numRef>
              <c:f>Sheet2!$O$31:$O$55</c:f>
              <c:numCache>
                <c:formatCode>General</c:formatCode>
                <c:ptCount val="2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  <c:pt idx="15">
                  <c:v>75</c:v>
                </c:pt>
                <c:pt idx="16">
                  <c:v>80</c:v>
                </c:pt>
                <c:pt idx="17">
                  <c:v>85</c:v>
                </c:pt>
                <c:pt idx="18">
                  <c:v>90</c:v>
                </c:pt>
                <c:pt idx="19">
                  <c:v>95</c:v>
                </c:pt>
                <c:pt idx="20">
                  <c:v>100</c:v>
                </c:pt>
                <c:pt idx="21">
                  <c:v>105</c:v>
                </c:pt>
                <c:pt idx="22">
                  <c:v>110</c:v>
                </c:pt>
                <c:pt idx="23">
                  <c:v>115</c:v>
                </c:pt>
                <c:pt idx="24">
                  <c:v>120</c:v>
                </c:pt>
              </c:numCache>
            </c:numRef>
          </c:cat>
          <c:val>
            <c:numRef>
              <c:f>Sheet2!$S$31:$S$55</c:f>
              <c:numCache>
                <c:formatCode>General</c:formatCode>
                <c:ptCount val="25"/>
                <c:pt idx="0">
                  <c:v>0.81223790137439167</c:v>
                </c:pt>
                <c:pt idx="1">
                  <c:v>1.0100809125878762</c:v>
                </c:pt>
                <c:pt idx="2">
                  <c:v>1.0637505484302141</c:v>
                </c:pt>
                <c:pt idx="3">
                  <c:v>1.9956737784035834</c:v>
                </c:pt>
                <c:pt idx="4">
                  <c:v>3.8375830297835867</c:v>
                </c:pt>
                <c:pt idx="5">
                  <c:v>4.8086871345924269</c:v>
                </c:pt>
                <c:pt idx="6">
                  <c:v>7.7388349811748149</c:v>
                </c:pt>
                <c:pt idx="7">
                  <c:v>8.8611527748017984</c:v>
                </c:pt>
                <c:pt idx="8">
                  <c:v>11.877314885671431</c:v>
                </c:pt>
                <c:pt idx="9">
                  <c:v>13.507555582764496</c:v>
                </c:pt>
                <c:pt idx="10">
                  <c:v>16.236238227881682</c:v>
                </c:pt>
                <c:pt idx="11">
                  <c:v>18.446998683767486</c:v>
                </c:pt>
                <c:pt idx="12">
                  <c:v>21.544328466334036</c:v>
                </c:pt>
                <c:pt idx="13">
                  <c:v>24.092411766506473</c:v>
                </c:pt>
                <c:pt idx="14">
                  <c:v>27.453804320099586</c:v>
                </c:pt>
                <c:pt idx="15">
                  <c:v>30.503841562337385</c:v>
                </c:pt>
                <c:pt idx="16">
                  <c:v>32.373656983684839</c:v>
                </c:pt>
                <c:pt idx="17">
                  <c:v>35.496954299182711</c:v>
                </c:pt>
                <c:pt idx="18">
                  <c:v>40.115042803065087</c:v>
                </c:pt>
                <c:pt idx="19">
                  <c:v>41.180936055587864</c:v>
                </c:pt>
                <c:pt idx="20">
                  <c:v>41.180936055587864</c:v>
                </c:pt>
                <c:pt idx="21">
                  <c:v>45.091115940698117</c:v>
                </c:pt>
                <c:pt idx="22">
                  <c:v>50.196669625638989</c:v>
                </c:pt>
                <c:pt idx="23">
                  <c:v>51.241901088697745</c:v>
                </c:pt>
                <c:pt idx="24">
                  <c:v>53.9337496301284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5F50-4047-AF11-8182496C9BE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41578175"/>
        <c:axId val="841570975"/>
      </c:lineChart>
      <c:catAx>
        <c:axId val="84157817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41570975"/>
        <c:crosses val="autoZero"/>
        <c:auto val="1"/>
        <c:lblAlgn val="ctr"/>
        <c:lblOffset val="100"/>
        <c:noMultiLvlLbl val="0"/>
      </c:catAx>
      <c:valAx>
        <c:axId val="841570975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41578175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DL11/1D3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4!$B$29</c:f>
              <c:strCache>
                <c:ptCount val="1"/>
                <c:pt idx="0">
                  <c:v>DL11</c:v>
                </c:pt>
              </c:strCache>
            </c:strRef>
          </c:tx>
          <c:spPr>
            <a:ln w="28575" cap="rnd">
              <a:solidFill>
                <a:srgbClr val="FF00FF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FF"/>
              </a:solidFill>
              <a:ln w="9525">
                <a:solidFill>
                  <a:srgbClr val="FF00FF"/>
                </a:solidFill>
              </a:ln>
              <a:effectLst/>
            </c:spPr>
          </c:marker>
          <c:cat>
            <c:numRef>
              <c:f>Sheet4!$A$30:$A$54</c:f>
              <c:numCache>
                <c:formatCode>General</c:formatCode>
                <c:ptCount val="2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  <c:pt idx="15">
                  <c:v>75</c:v>
                </c:pt>
                <c:pt idx="16">
                  <c:v>80</c:v>
                </c:pt>
                <c:pt idx="17">
                  <c:v>85</c:v>
                </c:pt>
                <c:pt idx="18">
                  <c:v>90</c:v>
                </c:pt>
                <c:pt idx="19">
                  <c:v>95</c:v>
                </c:pt>
                <c:pt idx="20">
                  <c:v>100</c:v>
                </c:pt>
                <c:pt idx="21">
                  <c:v>105</c:v>
                </c:pt>
                <c:pt idx="22">
                  <c:v>110</c:v>
                </c:pt>
                <c:pt idx="23">
                  <c:v>115</c:v>
                </c:pt>
                <c:pt idx="24">
                  <c:v>120</c:v>
                </c:pt>
              </c:numCache>
            </c:numRef>
          </c:cat>
          <c:val>
            <c:numRef>
              <c:f>Sheet4!$B$30:$B$54</c:f>
              <c:numCache>
                <c:formatCode>General</c:formatCode>
                <c:ptCount val="25"/>
                <c:pt idx="0">
                  <c:v>6.7888662593346916E-2</c:v>
                </c:pt>
                <c:pt idx="1">
                  <c:v>7.2414573432903376E-2</c:v>
                </c:pt>
                <c:pt idx="2">
                  <c:v>0.11314777098891152</c:v>
                </c:pt>
                <c:pt idx="3">
                  <c:v>0.2987101154107264</c:v>
                </c:pt>
                <c:pt idx="4">
                  <c:v>0.9685449196650826</c:v>
                </c:pt>
                <c:pt idx="5">
                  <c:v>2.0276080561212946</c:v>
                </c:pt>
                <c:pt idx="6">
                  <c:v>3.3627517537904503</c:v>
                </c:pt>
                <c:pt idx="7">
                  <c:v>4.5892735913102509</c:v>
                </c:pt>
                <c:pt idx="8">
                  <c:v>6.3091197103417063</c:v>
                </c:pt>
                <c:pt idx="9">
                  <c:v>7.5084860828241684</c:v>
                </c:pt>
                <c:pt idx="10">
                  <c:v>8.7033265444670747</c:v>
                </c:pt>
                <c:pt idx="11">
                  <c:v>10.549898167006109</c:v>
                </c:pt>
                <c:pt idx="12">
                  <c:v>12.016293279022403</c:v>
                </c:pt>
                <c:pt idx="13">
                  <c:v>13.496266123557366</c:v>
                </c:pt>
                <c:pt idx="14">
                  <c:v>15.012446254808781</c:v>
                </c:pt>
                <c:pt idx="15">
                  <c:v>16.48336727766463</c:v>
                </c:pt>
                <c:pt idx="16">
                  <c:v>18.873048200950443</c:v>
                </c:pt>
                <c:pt idx="17">
                  <c:v>20.090518216791128</c:v>
                </c:pt>
                <c:pt idx="18">
                  <c:v>22.131704005431093</c:v>
                </c:pt>
                <c:pt idx="19">
                  <c:v>24.213622991627066</c:v>
                </c:pt>
                <c:pt idx="20">
                  <c:v>25.734329033718037</c:v>
                </c:pt>
                <c:pt idx="21">
                  <c:v>28.282416836388322</c:v>
                </c:pt>
                <c:pt idx="22">
                  <c:v>31.821679112921476</c:v>
                </c:pt>
                <c:pt idx="23">
                  <c:v>33.876442634080107</c:v>
                </c:pt>
                <c:pt idx="24">
                  <c:v>35.79090291921249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2A6-4E8A-9798-2FF9A273A3AC}"/>
            </c:ext>
          </c:extLst>
        </c:ser>
        <c:ser>
          <c:idx val="1"/>
          <c:order val="1"/>
          <c:tx>
            <c:strRef>
              <c:f>Sheet4!$C$29</c:f>
              <c:strCache>
                <c:ptCount val="1"/>
                <c:pt idx="0">
                  <c:v>1D3</c:v>
                </c:pt>
              </c:strCache>
            </c:strRef>
          </c:tx>
          <c:spPr>
            <a:ln w="28575" cap="rnd">
              <a:solidFill>
                <a:srgbClr val="FFC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C000"/>
              </a:solidFill>
              <a:ln w="9525">
                <a:solidFill>
                  <a:srgbClr val="FFC000"/>
                </a:solidFill>
              </a:ln>
              <a:effectLst/>
            </c:spPr>
          </c:marker>
          <c:cat>
            <c:numRef>
              <c:f>Sheet4!$A$30:$A$54</c:f>
              <c:numCache>
                <c:formatCode>General</c:formatCode>
                <c:ptCount val="2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  <c:pt idx="15">
                  <c:v>75</c:v>
                </c:pt>
                <c:pt idx="16">
                  <c:v>80</c:v>
                </c:pt>
                <c:pt idx="17">
                  <c:v>85</c:v>
                </c:pt>
                <c:pt idx="18">
                  <c:v>90</c:v>
                </c:pt>
                <c:pt idx="19">
                  <c:v>95</c:v>
                </c:pt>
                <c:pt idx="20">
                  <c:v>100</c:v>
                </c:pt>
                <c:pt idx="21">
                  <c:v>105</c:v>
                </c:pt>
                <c:pt idx="22">
                  <c:v>110</c:v>
                </c:pt>
                <c:pt idx="23">
                  <c:v>115</c:v>
                </c:pt>
                <c:pt idx="24">
                  <c:v>120</c:v>
                </c:pt>
              </c:numCache>
            </c:numRef>
          </c:cat>
          <c:val>
            <c:numRef>
              <c:f>Sheet4!$C$30:$C$54</c:f>
              <c:numCache>
                <c:formatCode>General</c:formatCode>
                <c:ptCount val="25"/>
                <c:pt idx="0">
                  <c:v>6.3362751753790456E-2</c:v>
                </c:pt>
                <c:pt idx="1">
                  <c:v>8.5992305951572756E-2</c:v>
                </c:pt>
                <c:pt idx="2">
                  <c:v>0.25797691785471827</c:v>
                </c:pt>
                <c:pt idx="3">
                  <c:v>1.2355736591989137</c:v>
                </c:pt>
                <c:pt idx="4">
                  <c:v>3.2179226069246436</c:v>
                </c:pt>
                <c:pt idx="5">
                  <c:v>6.1371350984385611</c:v>
                </c:pt>
                <c:pt idx="6">
                  <c:v>8.9024666214075587</c:v>
                </c:pt>
                <c:pt idx="7">
                  <c:v>11.541072640868975</c:v>
                </c:pt>
                <c:pt idx="8">
                  <c:v>14.777098891151844</c:v>
                </c:pt>
                <c:pt idx="9">
                  <c:v>17.298031228784794</c:v>
                </c:pt>
                <c:pt idx="10">
                  <c:v>20.35754695632496</c:v>
                </c:pt>
                <c:pt idx="11">
                  <c:v>22.344421814890246</c:v>
                </c:pt>
                <c:pt idx="12">
                  <c:v>26.241231047748361</c:v>
                </c:pt>
                <c:pt idx="13">
                  <c:v>28.784792939579091</c:v>
                </c:pt>
                <c:pt idx="14">
                  <c:v>32.464358452138491</c:v>
                </c:pt>
                <c:pt idx="15">
                  <c:v>34.523647884136679</c:v>
                </c:pt>
                <c:pt idx="16">
                  <c:v>38.153428377460962</c:v>
                </c:pt>
                <c:pt idx="17">
                  <c:v>42.434940031681379</c:v>
                </c:pt>
                <c:pt idx="18">
                  <c:v>45.566870332654446</c:v>
                </c:pt>
                <c:pt idx="19">
                  <c:v>48.504186467526587</c:v>
                </c:pt>
                <c:pt idx="20">
                  <c:v>52.604661688164747</c:v>
                </c:pt>
                <c:pt idx="21">
                  <c:v>54.876668929622085</c:v>
                </c:pt>
                <c:pt idx="22">
                  <c:v>61.412084181941616</c:v>
                </c:pt>
                <c:pt idx="23">
                  <c:v>65.363204344874404</c:v>
                </c:pt>
                <c:pt idx="24">
                  <c:v>69.2690653994116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2A6-4E8A-9798-2FF9A273A3AC}"/>
            </c:ext>
          </c:extLst>
        </c:ser>
        <c:ser>
          <c:idx val="2"/>
          <c:order val="2"/>
          <c:tx>
            <c:strRef>
              <c:f>Sheet4!$D$29</c:f>
              <c:strCache>
                <c:ptCount val="1"/>
                <c:pt idx="0">
                  <c:v>DL11+1D3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numRef>
              <c:f>Sheet4!$A$30:$A$54</c:f>
              <c:numCache>
                <c:formatCode>General</c:formatCode>
                <c:ptCount val="2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  <c:pt idx="15">
                  <c:v>75</c:v>
                </c:pt>
                <c:pt idx="16">
                  <c:v>80</c:v>
                </c:pt>
                <c:pt idx="17">
                  <c:v>85</c:v>
                </c:pt>
                <c:pt idx="18">
                  <c:v>90</c:v>
                </c:pt>
                <c:pt idx="19">
                  <c:v>95</c:v>
                </c:pt>
                <c:pt idx="20">
                  <c:v>100</c:v>
                </c:pt>
                <c:pt idx="21">
                  <c:v>105</c:v>
                </c:pt>
                <c:pt idx="22">
                  <c:v>110</c:v>
                </c:pt>
                <c:pt idx="23">
                  <c:v>115</c:v>
                </c:pt>
                <c:pt idx="24">
                  <c:v>120</c:v>
                </c:pt>
              </c:numCache>
            </c:numRef>
          </c:cat>
          <c:val>
            <c:numRef>
              <c:f>Sheet4!$D$30:$D$54</c:f>
              <c:numCache>
                <c:formatCode>General</c:formatCode>
                <c:ptCount val="25"/>
                <c:pt idx="0">
                  <c:v>7.2414573432903376E-2</c:v>
                </c:pt>
                <c:pt idx="1">
                  <c:v>9.5044127630685676E-2</c:v>
                </c:pt>
                <c:pt idx="2">
                  <c:v>0.13577732518669383</c:v>
                </c:pt>
                <c:pt idx="3">
                  <c:v>0.16745870106358904</c:v>
                </c:pt>
                <c:pt idx="4">
                  <c:v>0.49332428151165419</c:v>
                </c:pt>
                <c:pt idx="5">
                  <c:v>0.88255261371350979</c:v>
                </c:pt>
                <c:pt idx="6">
                  <c:v>1.6157501697216565</c:v>
                </c:pt>
                <c:pt idx="7">
                  <c:v>2.2131704005431092</c:v>
                </c:pt>
                <c:pt idx="8">
                  <c:v>2.9101606698348044</c:v>
                </c:pt>
                <c:pt idx="9">
                  <c:v>3.5211586331749265</c:v>
                </c:pt>
                <c:pt idx="10">
                  <c:v>4.1457343290337176</c:v>
                </c:pt>
                <c:pt idx="11">
                  <c:v>4.8698800633627517</c:v>
                </c:pt>
                <c:pt idx="12">
                  <c:v>5.7614844987553742</c:v>
                </c:pt>
                <c:pt idx="13">
                  <c:v>6.5127856981217471</c:v>
                </c:pt>
                <c:pt idx="14">
                  <c:v>7.0196877121520709</c:v>
                </c:pt>
                <c:pt idx="15">
                  <c:v>8.1873727087576373</c:v>
                </c:pt>
                <c:pt idx="16">
                  <c:v>9.0020366598778008</c:v>
                </c:pt>
                <c:pt idx="17">
                  <c:v>10.3326544467074</c:v>
                </c:pt>
                <c:pt idx="18">
                  <c:v>11.169947952025344</c:v>
                </c:pt>
                <c:pt idx="19">
                  <c:v>12.08418194161575</c:v>
                </c:pt>
                <c:pt idx="20">
                  <c:v>13.54152523195293</c:v>
                </c:pt>
                <c:pt idx="21">
                  <c:v>14.695632496039828</c:v>
                </c:pt>
                <c:pt idx="22">
                  <c:v>16.13939805385834</c:v>
                </c:pt>
                <c:pt idx="23">
                  <c:v>17.026476578411405</c:v>
                </c:pt>
                <c:pt idx="24">
                  <c:v>18.85947046843177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12A6-4E8A-9798-2FF9A273A3AC}"/>
            </c:ext>
          </c:extLst>
        </c:ser>
        <c:ser>
          <c:idx val="3"/>
          <c:order val="3"/>
          <c:tx>
            <c:strRef>
              <c:f>Sheet4!$E$29</c:f>
              <c:strCache>
                <c:ptCount val="1"/>
                <c:pt idx="0">
                  <c:v>DL11/1D3</c:v>
                </c:pt>
              </c:strCache>
            </c:strRef>
          </c:tx>
          <c:spPr>
            <a:ln w="28575" cap="rnd">
              <a:solidFill>
                <a:schemeClr val="bg1">
                  <a:lumMod val="6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bg1">
                  <a:lumMod val="65000"/>
                </a:schemeClr>
              </a:solidFill>
              <a:ln w="9525">
                <a:solidFill>
                  <a:schemeClr val="bg1">
                    <a:lumMod val="65000"/>
                  </a:schemeClr>
                </a:solidFill>
              </a:ln>
              <a:effectLst/>
            </c:spPr>
          </c:marker>
          <c:cat>
            <c:numRef>
              <c:f>Sheet4!$A$30:$A$54</c:f>
              <c:numCache>
                <c:formatCode>General</c:formatCode>
                <c:ptCount val="2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  <c:pt idx="15">
                  <c:v>75</c:v>
                </c:pt>
                <c:pt idx="16">
                  <c:v>80</c:v>
                </c:pt>
                <c:pt idx="17">
                  <c:v>85</c:v>
                </c:pt>
                <c:pt idx="18">
                  <c:v>90</c:v>
                </c:pt>
                <c:pt idx="19">
                  <c:v>95</c:v>
                </c:pt>
                <c:pt idx="20">
                  <c:v>100</c:v>
                </c:pt>
                <c:pt idx="21">
                  <c:v>105</c:v>
                </c:pt>
                <c:pt idx="22">
                  <c:v>110</c:v>
                </c:pt>
                <c:pt idx="23">
                  <c:v>115</c:v>
                </c:pt>
                <c:pt idx="24">
                  <c:v>120</c:v>
                </c:pt>
              </c:numCache>
            </c:numRef>
          </c:cat>
          <c:val>
            <c:numRef>
              <c:f>Sheet4!$E$30:$E$54</c:f>
              <c:numCache>
                <c:formatCode>General</c:formatCode>
                <c:ptCount val="25"/>
                <c:pt idx="0">
                  <c:v>5.8836840914233988E-2</c:v>
                </c:pt>
                <c:pt idx="1">
                  <c:v>7.2414573432903376E-2</c:v>
                </c:pt>
                <c:pt idx="2">
                  <c:v>9.9570038470242136E-2</c:v>
                </c:pt>
                <c:pt idx="3">
                  <c:v>0.18103643358225843</c:v>
                </c:pt>
                <c:pt idx="4">
                  <c:v>0.39828015388096855</c:v>
                </c:pt>
                <c:pt idx="5">
                  <c:v>0.80561212944104998</c:v>
                </c:pt>
                <c:pt idx="6">
                  <c:v>1.2898845892735913</c:v>
                </c:pt>
                <c:pt idx="7">
                  <c:v>1.5523874179678661</c:v>
                </c:pt>
                <c:pt idx="8">
                  <c:v>2.1724372029871013</c:v>
                </c:pt>
                <c:pt idx="9">
                  <c:v>2.7834351663272234</c:v>
                </c:pt>
                <c:pt idx="10">
                  <c:v>3.584521384928717</c:v>
                </c:pt>
                <c:pt idx="11">
                  <c:v>4.0914233989590407</c:v>
                </c:pt>
                <c:pt idx="12">
                  <c:v>4.7205250056573886</c:v>
                </c:pt>
                <c:pt idx="13">
                  <c:v>5.3722561665535187</c:v>
                </c:pt>
                <c:pt idx="14">
                  <c:v>6.1235573659198916</c:v>
                </c:pt>
                <c:pt idx="15">
                  <c:v>6.9020140303236026</c:v>
                </c:pt>
                <c:pt idx="16">
                  <c:v>7.9520253451007017</c:v>
                </c:pt>
                <c:pt idx="17">
                  <c:v>8.4498755374519128</c:v>
                </c:pt>
                <c:pt idx="18">
                  <c:v>9.2238062910160679</c:v>
                </c:pt>
                <c:pt idx="19">
                  <c:v>10.540846345326997</c:v>
                </c:pt>
                <c:pt idx="20">
                  <c:v>11.323828920570264</c:v>
                </c:pt>
                <c:pt idx="21">
                  <c:v>12.183751980085992</c:v>
                </c:pt>
                <c:pt idx="22">
                  <c:v>14.482914686580674</c:v>
                </c:pt>
                <c:pt idx="23">
                  <c:v>15.686806969902692</c:v>
                </c:pt>
                <c:pt idx="24">
                  <c:v>17.15320208191898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12A6-4E8A-9798-2FF9A273A3A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56949919"/>
        <c:axId val="856951839"/>
      </c:lineChart>
      <c:catAx>
        <c:axId val="8569499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56951839"/>
        <c:crosses val="autoZero"/>
        <c:auto val="1"/>
        <c:lblAlgn val="ctr"/>
        <c:lblOffset val="100"/>
        <c:noMultiLvlLbl val="0"/>
      </c:catAx>
      <c:valAx>
        <c:axId val="856951839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56949919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DL11/1D3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4!$G$29</c:f>
              <c:strCache>
                <c:ptCount val="1"/>
                <c:pt idx="0">
                  <c:v>DL11</c:v>
                </c:pt>
              </c:strCache>
            </c:strRef>
          </c:tx>
          <c:spPr>
            <a:ln w="28575" cap="rnd">
              <a:solidFill>
                <a:srgbClr val="FF00FF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FF"/>
              </a:solidFill>
              <a:ln w="9525">
                <a:solidFill>
                  <a:srgbClr val="FF00FF"/>
                </a:solidFill>
              </a:ln>
              <a:effectLst/>
            </c:spPr>
          </c:marker>
          <c:cat>
            <c:numRef>
              <c:f>Sheet4!$F$30:$F$54</c:f>
              <c:numCache>
                <c:formatCode>General</c:formatCode>
                <c:ptCount val="2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  <c:pt idx="15">
                  <c:v>75</c:v>
                </c:pt>
                <c:pt idx="16">
                  <c:v>80</c:v>
                </c:pt>
                <c:pt idx="17">
                  <c:v>85</c:v>
                </c:pt>
                <c:pt idx="18">
                  <c:v>90</c:v>
                </c:pt>
                <c:pt idx="19">
                  <c:v>95</c:v>
                </c:pt>
                <c:pt idx="20">
                  <c:v>100</c:v>
                </c:pt>
                <c:pt idx="21">
                  <c:v>105</c:v>
                </c:pt>
                <c:pt idx="22">
                  <c:v>110</c:v>
                </c:pt>
                <c:pt idx="23">
                  <c:v>115</c:v>
                </c:pt>
                <c:pt idx="24">
                  <c:v>120</c:v>
                </c:pt>
              </c:numCache>
            </c:numRef>
          </c:cat>
          <c:val>
            <c:numRef>
              <c:f>Sheet4!$G$30:$G$54</c:f>
              <c:numCache>
                <c:formatCode>General</c:formatCode>
                <c:ptCount val="25"/>
                <c:pt idx="0">
                  <c:v>7.0604209097080803E-2</c:v>
                </c:pt>
                <c:pt idx="1">
                  <c:v>0.11767368182846798</c:v>
                </c:pt>
                <c:pt idx="2">
                  <c:v>0.18827789092554878</c:v>
                </c:pt>
                <c:pt idx="3">
                  <c:v>0.38243946594252093</c:v>
                </c:pt>
                <c:pt idx="4">
                  <c:v>0.9649241909934374</c:v>
                </c:pt>
                <c:pt idx="5">
                  <c:v>1.7827562797012899</c:v>
                </c:pt>
                <c:pt idx="6">
                  <c:v>2.8477031002489253</c:v>
                </c:pt>
                <c:pt idx="7">
                  <c:v>3.6831862412310477</c:v>
                </c:pt>
                <c:pt idx="8">
                  <c:v>4.8481556913328809</c:v>
                </c:pt>
                <c:pt idx="9">
                  <c:v>6.589726182394207</c:v>
                </c:pt>
                <c:pt idx="10">
                  <c:v>7.8252998415931208</c:v>
                </c:pt>
                <c:pt idx="11">
                  <c:v>9.3374066530889337</c:v>
                </c:pt>
                <c:pt idx="12">
                  <c:v>10.690653994116316</c:v>
                </c:pt>
                <c:pt idx="13">
                  <c:v>12.267481330617787</c:v>
                </c:pt>
                <c:pt idx="14">
                  <c:v>13.073546051142792</c:v>
                </c:pt>
                <c:pt idx="15">
                  <c:v>14.821000226295542</c:v>
                </c:pt>
                <c:pt idx="16">
                  <c:v>16.433129667345554</c:v>
                </c:pt>
                <c:pt idx="17">
                  <c:v>17.721656483367276</c:v>
                </c:pt>
                <c:pt idx="18">
                  <c:v>19.680923285811268</c:v>
                </c:pt>
                <c:pt idx="19">
                  <c:v>21.275401674587009</c:v>
                </c:pt>
                <c:pt idx="20">
                  <c:v>22.934600588368411</c:v>
                </c:pt>
                <c:pt idx="21">
                  <c:v>24.570264765784113</c:v>
                </c:pt>
                <c:pt idx="22">
                  <c:v>27.988685222901108</c:v>
                </c:pt>
                <c:pt idx="23">
                  <c:v>29.418420457116994</c:v>
                </c:pt>
                <c:pt idx="24">
                  <c:v>32.0366598778004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CB6-4556-88E2-3654BCE54034}"/>
            </c:ext>
          </c:extLst>
        </c:ser>
        <c:ser>
          <c:idx val="1"/>
          <c:order val="1"/>
          <c:tx>
            <c:strRef>
              <c:f>Sheet4!$H$29</c:f>
              <c:strCache>
                <c:ptCount val="1"/>
                <c:pt idx="0">
                  <c:v>1D3</c:v>
                </c:pt>
              </c:strCache>
            </c:strRef>
          </c:tx>
          <c:spPr>
            <a:ln w="28575" cap="rnd">
              <a:solidFill>
                <a:srgbClr val="FFC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C000"/>
              </a:solidFill>
              <a:ln w="9525">
                <a:solidFill>
                  <a:srgbClr val="FFC000"/>
                </a:solidFill>
              </a:ln>
              <a:effectLst/>
            </c:spPr>
          </c:marker>
          <c:cat>
            <c:numRef>
              <c:f>Sheet4!$F$30:$F$54</c:f>
              <c:numCache>
                <c:formatCode>General</c:formatCode>
                <c:ptCount val="2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  <c:pt idx="15">
                  <c:v>75</c:v>
                </c:pt>
                <c:pt idx="16">
                  <c:v>80</c:v>
                </c:pt>
                <c:pt idx="17">
                  <c:v>85</c:v>
                </c:pt>
                <c:pt idx="18">
                  <c:v>90</c:v>
                </c:pt>
                <c:pt idx="19">
                  <c:v>95</c:v>
                </c:pt>
                <c:pt idx="20">
                  <c:v>100</c:v>
                </c:pt>
                <c:pt idx="21">
                  <c:v>105</c:v>
                </c:pt>
                <c:pt idx="22">
                  <c:v>110</c:v>
                </c:pt>
                <c:pt idx="23">
                  <c:v>115</c:v>
                </c:pt>
                <c:pt idx="24">
                  <c:v>120</c:v>
                </c:pt>
              </c:numCache>
            </c:numRef>
          </c:cat>
          <c:val>
            <c:numRef>
              <c:f>Sheet4!$H$30:$H$54</c:f>
              <c:numCache>
                <c:formatCode>General</c:formatCode>
                <c:ptCount val="25"/>
                <c:pt idx="0">
                  <c:v>7.6940484272459836E-2</c:v>
                </c:pt>
                <c:pt idx="1">
                  <c:v>6.7888662593346916E-2</c:v>
                </c:pt>
                <c:pt idx="2">
                  <c:v>0.17651052274270196</c:v>
                </c:pt>
                <c:pt idx="3">
                  <c:v>1.1269517990495588</c:v>
                </c:pt>
                <c:pt idx="4">
                  <c:v>3.0006788866259333</c:v>
                </c:pt>
                <c:pt idx="5">
                  <c:v>5.5125594025797691</c:v>
                </c:pt>
                <c:pt idx="6">
                  <c:v>7.6080561212944104</c:v>
                </c:pt>
                <c:pt idx="7">
                  <c:v>10.341706268386513</c:v>
                </c:pt>
                <c:pt idx="8">
                  <c:v>12.342158859470468</c:v>
                </c:pt>
                <c:pt idx="9">
                  <c:v>14.605114279248699</c:v>
                </c:pt>
                <c:pt idx="10">
                  <c:v>16.582937316134871</c:v>
                </c:pt>
                <c:pt idx="11">
                  <c:v>19.280380176510523</c:v>
                </c:pt>
                <c:pt idx="12">
                  <c:v>21.864675265897262</c:v>
                </c:pt>
                <c:pt idx="13">
                  <c:v>24.485177642000451</c:v>
                </c:pt>
                <c:pt idx="14">
                  <c:v>26.10997963340122</c:v>
                </c:pt>
                <c:pt idx="15">
                  <c:v>29.033718035754696</c:v>
                </c:pt>
                <c:pt idx="16">
                  <c:v>31.663272233537</c:v>
                </c:pt>
                <c:pt idx="17">
                  <c:v>34.193256392849058</c:v>
                </c:pt>
                <c:pt idx="18">
                  <c:v>37.488119484046166</c:v>
                </c:pt>
                <c:pt idx="19">
                  <c:v>40.022629554197785</c:v>
                </c:pt>
                <c:pt idx="20">
                  <c:v>42.828694274722785</c:v>
                </c:pt>
                <c:pt idx="21">
                  <c:v>45.598551708531339</c:v>
                </c:pt>
                <c:pt idx="22">
                  <c:v>49.689975107490383</c:v>
                </c:pt>
                <c:pt idx="23">
                  <c:v>53.858338990721883</c:v>
                </c:pt>
                <c:pt idx="24">
                  <c:v>56.6779814437655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CB6-4556-88E2-3654BCE54034}"/>
            </c:ext>
          </c:extLst>
        </c:ser>
        <c:ser>
          <c:idx val="2"/>
          <c:order val="2"/>
          <c:tx>
            <c:strRef>
              <c:f>Sheet4!$I$29</c:f>
              <c:strCache>
                <c:ptCount val="1"/>
                <c:pt idx="0">
                  <c:v>DL11+1D3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numRef>
              <c:f>Sheet4!$F$30:$F$54</c:f>
              <c:numCache>
                <c:formatCode>General</c:formatCode>
                <c:ptCount val="2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  <c:pt idx="15">
                  <c:v>75</c:v>
                </c:pt>
                <c:pt idx="16">
                  <c:v>80</c:v>
                </c:pt>
                <c:pt idx="17">
                  <c:v>85</c:v>
                </c:pt>
                <c:pt idx="18">
                  <c:v>90</c:v>
                </c:pt>
                <c:pt idx="19">
                  <c:v>95</c:v>
                </c:pt>
                <c:pt idx="20">
                  <c:v>100</c:v>
                </c:pt>
                <c:pt idx="21">
                  <c:v>105</c:v>
                </c:pt>
                <c:pt idx="22">
                  <c:v>110</c:v>
                </c:pt>
                <c:pt idx="23">
                  <c:v>115</c:v>
                </c:pt>
                <c:pt idx="24">
                  <c:v>120</c:v>
                </c:pt>
              </c:numCache>
            </c:numRef>
          </c:cat>
          <c:val>
            <c:numRef>
              <c:f>Sheet4!$I$30:$I$54</c:f>
              <c:numCache>
                <c:formatCode>General</c:formatCode>
                <c:ptCount val="25"/>
                <c:pt idx="0">
                  <c:v>5.8836840914233988E-2</c:v>
                </c:pt>
                <c:pt idx="1">
                  <c:v>6.3362751753790456E-2</c:v>
                </c:pt>
                <c:pt idx="2">
                  <c:v>0.12219959266802444</c:v>
                </c:pt>
                <c:pt idx="3">
                  <c:v>0.21724372029871011</c:v>
                </c:pt>
                <c:pt idx="4">
                  <c:v>0.6924643584521385</c:v>
                </c:pt>
                <c:pt idx="5">
                  <c:v>1.2808327675944784</c:v>
                </c:pt>
                <c:pt idx="6">
                  <c:v>2.2267481330617787</c:v>
                </c:pt>
                <c:pt idx="7">
                  <c:v>3.1228784792939579</c:v>
                </c:pt>
                <c:pt idx="8">
                  <c:v>4.0687938447612586</c:v>
                </c:pt>
                <c:pt idx="9">
                  <c:v>4.9603982801538811</c:v>
                </c:pt>
                <c:pt idx="10">
                  <c:v>6.1099796334012222</c:v>
                </c:pt>
                <c:pt idx="11">
                  <c:v>6.7119257750622312</c:v>
                </c:pt>
                <c:pt idx="12">
                  <c:v>7.4677528852681601</c:v>
                </c:pt>
                <c:pt idx="13">
                  <c:v>8.3140982122652183</c:v>
                </c:pt>
                <c:pt idx="14">
                  <c:v>9.5315682281059058</c:v>
                </c:pt>
                <c:pt idx="15">
                  <c:v>10.531794523647884</c:v>
                </c:pt>
                <c:pt idx="16">
                  <c:v>11.500339443312967</c:v>
                </c:pt>
                <c:pt idx="17">
                  <c:v>11.966508259787282</c:v>
                </c:pt>
                <c:pt idx="18">
                  <c:v>13.745191219732972</c:v>
                </c:pt>
                <c:pt idx="19">
                  <c:v>15.112016293279023</c:v>
                </c:pt>
                <c:pt idx="20">
                  <c:v>16.297804933242816</c:v>
                </c:pt>
                <c:pt idx="21">
                  <c:v>17.574111789997737</c:v>
                </c:pt>
                <c:pt idx="22">
                  <c:v>19.837067209775967</c:v>
                </c:pt>
                <c:pt idx="23">
                  <c:v>21.692690653994116</c:v>
                </c:pt>
                <c:pt idx="24">
                  <c:v>23.47589952477936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5CB6-4556-88E2-3654BCE54034}"/>
            </c:ext>
          </c:extLst>
        </c:ser>
        <c:ser>
          <c:idx val="3"/>
          <c:order val="3"/>
          <c:tx>
            <c:strRef>
              <c:f>Sheet4!$J$29</c:f>
              <c:strCache>
                <c:ptCount val="1"/>
                <c:pt idx="0">
                  <c:v>DL11/1D3</c:v>
                </c:pt>
              </c:strCache>
            </c:strRef>
          </c:tx>
          <c:spPr>
            <a:ln w="28575" cap="rnd">
              <a:solidFill>
                <a:schemeClr val="bg1">
                  <a:lumMod val="6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bg1">
                  <a:lumMod val="65000"/>
                </a:schemeClr>
              </a:solidFill>
              <a:ln w="9525">
                <a:solidFill>
                  <a:schemeClr val="bg1">
                    <a:lumMod val="65000"/>
                  </a:schemeClr>
                </a:solidFill>
              </a:ln>
              <a:effectLst/>
            </c:spPr>
          </c:marker>
          <c:cat>
            <c:numRef>
              <c:f>Sheet4!$F$30:$F$54</c:f>
              <c:numCache>
                <c:formatCode>General</c:formatCode>
                <c:ptCount val="2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  <c:pt idx="15">
                  <c:v>75</c:v>
                </c:pt>
                <c:pt idx="16">
                  <c:v>80</c:v>
                </c:pt>
                <c:pt idx="17">
                  <c:v>85</c:v>
                </c:pt>
                <c:pt idx="18">
                  <c:v>90</c:v>
                </c:pt>
                <c:pt idx="19">
                  <c:v>95</c:v>
                </c:pt>
                <c:pt idx="20">
                  <c:v>100</c:v>
                </c:pt>
                <c:pt idx="21">
                  <c:v>105</c:v>
                </c:pt>
                <c:pt idx="22">
                  <c:v>110</c:v>
                </c:pt>
                <c:pt idx="23">
                  <c:v>115</c:v>
                </c:pt>
                <c:pt idx="24">
                  <c:v>120</c:v>
                </c:pt>
              </c:numCache>
            </c:numRef>
          </c:cat>
          <c:val>
            <c:numRef>
              <c:f>Sheet4!$J$30:$J$54</c:f>
              <c:numCache>
                <c:formatCode>General</c:formatCode>
                <c:ptCount val="25"/>
                <c:pt idx="0">
                  <c:v>0.1040959493097986</c:v>
                </c:pt>
                <c:pt idx="1">
                  <c:v>8.1466395112016296E-2</c:v>
                </c:pt>
                <c:pt idx="2">
                  <c:v>0.12219959266802444</c:v>
                </c:pt>
                <c:pt idx="3">
                  <c:v>0.16745870106358904</c:v>
                </c:pt>
                <c:pt idx="4">
                  <c:v>0.46164290563475902</c:v>
                </c:pt>
                <c:pt idx="5">
                  <c:v>1.0092781172210907</c:v>
                </c:pt>
                <c:pt idx="6">
                  <c:v>1.5931206155238742</c:v>
                </c:pt>
                <c:pt idx="7">
                  <c:v>2.2176963113826655</c:v>
                </c:pt>
                <c:pt idx="8">
                  <c:v>2.7924869880063361</c:v>
                </c:pt>
                <c:pt idx="9">
                  <c:v>3.3627517537904503</c:v>
                </c:pt>
                <c:pt idx="10">
                  <c:v>3.8379723919438788</c:v>
                </c:pt>
                <c:pt idx="11">
                  <c:v>4.7341027381760581</c:v>
                </c:pt>
                <c:pt idx="12">
                  <c:v>5.4310930074677533</c:v>
                </c:pt>
                <c:pt idx="13">
                  <c:v>5.9515727540167456</c:v>
                </c:pt>
                <c:pt idx="14">
                  <c:v>6.9155917628422721</c:v>
                </c:pt>
                <c:pt idx="15">
                  <c:v>7.8117221090744513</c:v>
                </c:pt>
                <c:pt idx="16">
                  <c:v>8.6037565059968326</c:v>
                </c:pt>
                <c:pt idx="17">
                  <c:v>9.9207965603077621</c:v>
                </c:pt>
                <c:pt idx="18">
                  <c:v>10.604209097080787</c:v>
                </c:pt>
                <c:pt idx="19">
                  <c:v>11.618013125141434</c:v>
                </c:pt>
                <c:pt idx="20">
                  <c:v>12.758542656709663</c:v>
                </c:pt>
                <c:pt idx="21">
                  <c:v>13.908124009957003</c:v>
                </c:pt>
                <c:pt idx="22">
                  <c:v>15.799954740891604</c:v>
                </c:pt>
                <c:pt idx="23">
                  <c:v>17.207513011993665</c:v>
                </c:pt>
                <c:pt idx="24">
                  <c:v>18.73274496492419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5CB6-4556-88E2-3654BCE5403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57527423"/>
        <c:axId val="857529343"/>
      </c:lineChart>
      <c:catAx>
        <c:axId val="85752742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57529343"/>
        <c:crosses val="autoZero"/>
        <c:auto val="1"/>
        <c:lblAlgn val="ctr"/>
        <c:lblOffset val="100"/>
        <c:noMultiLvlLbl val="0"/>
      </c:catAx>
      <c:valAx>
        <c:axId val="857529343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57527423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E6777-0B24-4C3D-8AEC-AB7117AFDE28}" type="datetimeFigureOut">
              <a:rPr lang="en-US" smtClean="0"/>
              <a:t>1/3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B4555-B9C7-4BCC-AE1A-BB0E69913D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95828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E6777-0B24-4C3D-8AEC-AB7117AFDE28}" type="datetimeFigureOut">
              <a:rPr lang="en-US" smtClean="0"/>
              <a:t>1/3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B4555-B9C7-4BCC-AE1A-BB0E69913D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42036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E6777-0B24-4C3D-8AEC-AB7117AFDE28}" type="datetimeFigureOut">
              <a:rPr lang="en-US" smtClean="0"/>
              <a:t>1/3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B4555-B9C7-4BCC-AE1A-BB0E69913D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98222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E6777-0B24-4C3D-8AEC-AB7117AFDE28}" type="datetimeFigureOut">
              <a:rPr lang="en-US" smtClean="0"/>
              <a:t>1/3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B4555-B9C7-4BCC-AE1A-BB0E69913D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10841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E6777-0B24-4C3D-8AEC-AB7117AFDE28}" type="datetimeFigureOut">
              <a:rPr lang="en-US" smtClean="0"/>
              <a:t>1/3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B4555-B9C7-4BCC-AE1A-BB0E69913D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55355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E6777-0B24-4C3D-8AEC-AB7117AFDE28}" type="datetimeFigureOut">
              <a:rPr lang="en-US" smtClean="0"/>
              <a:t>1/3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B4555-B9C7-4BCC-AE1A-BB0E69913D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97591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E6777-0B24-4C3D-8AEC-AB7117AFDE28}" type="datetimeFigureOut">
              <a:rPr lang="en-US" smtClean="0"/>
              <a:t>1/31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B4555-B9C7-4BCC-AE1A-BB0E69913D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16288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E6777-0B24-4C3D-8AEC-AB7117AFDE28}" type="datetimeFigureOut">
              <a:rPr lang="en-US" smtClean="0"/>
              <a:t>1/31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B4555-B9C7-4BCC-AE1A-BB0E69913D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57181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E6777-0B24-4C3D-8AEC-AB7117AFDE28}" type="datetimeFigureOut">
              <a:rPr lang="en-US" smtClean="0"/>
              <a:t>1/31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B4555-B9C7-4BCC-AE1A-BB0E69913D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35456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E6777-0B24-4C3D-8AEC-AB7117AFDE28}" type="datetimeFigureOut">
              <a:rPr lang="en-US" smtClean="0"/>
              <a:t>1/3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B4555-B9C7-4BCC-AE1A-BB0E69913D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40694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E6777-0B24-4C3D-8AEC-AB7117AFDE28}" type="datetimeFigureOut">
              <a:rPr lang="en-US" smtClean="0"/>
              <a:t>1/3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B4555-B9C7-4BCC-AE1A-BB0E69913D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9827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C4E6777-0B24-4C3D-8AEC-AB7117AFDE28}" type="datetimeFigureOut">
              <a:rPr lang="en-US" smtClean="0"/>
              <a:t>1/3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17B4555-B9C7-4BCC-AE1A-BB0E69913D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10568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38177D72-EF56-A152-ADEC-F4FCF4B80DD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04088492"/>
              </p:ext>
            </p:extLst>
          </p:nvPr>
        </p:nvGraphicFramePr>
        <p:xfrm>
          <a:off x="369403" y="65337"/>
          <a:ext cx="2298246" cy="30307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07DAC558-6123-EAED-B30D-350710A7EEE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35356406"/>
              </p:ext>
            </p:extLst>
          </p:nvPr>
        </p:nvGraphicFramePr>
        <p:xfrm>
          <a:off x="3169753" y="65337"/>
          <a:ext cx="2298246" cy="30307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FB2640DA-AF00-B6CA-2A43-E6034B42BD9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20984111"/>
              </p:ext>
            </p:extLst>
          </p:nvPr>
        </p:nvGraphicFramePr>
        <p:xfrm>
          <a:off x="369403" y="3754323"/>
          <a:ext cx="2316615" cy="33245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35659079-E7C7-5054-21FF-3E04A51D0D0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00759345"/>
              </p:ext>
            </p:extLst>
          </p:nvPr>
        </p:nvGraphicFramePr>
        <p:xfrm>
          <a:off x="3169753" y="3754323"/>
          <a:ext cx="2316615" cy="33245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9CAA46D1-64F1-74DC-A082-8113319AFD2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61811216"/>
              </p:ext>
            </p:extLst>
          </p:nvPr>
        </p:nvGraphicFramePr>
        <p:xfrm>
          <a:off x="351034" y="7756540"/>
          <a:ext cx="2316615" cy="33245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id="{499417DF-1AF3-313A-4F4C-D5A6C6275A9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80231753"/>
              </p:ext>
            </p:extLst>
          </p:nvPr>
        </p:nvGraphicFramePr>
        <p:xfrm>
          <a:off x="3429000" y="7756540"/>
          <a:ext cx="2316615" cy="33245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id="{6C6CCC5A-4B5D-70A6-597E-AD2FD7AA828D}"/>
              </a:ext>
            </a:extLst>
          </p:cNvPr>
          <p:cNvSpPr txBox="1"/>
          <p:nvPr/>
        </p:nvSpPr>
        <p:spPr>
          <a:xfrm>
            <a:off x="0" y="11435591"/>
            <a:ext cx="6858000" cy="7848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Supplemental </a:t>
            </a:r>
            <a:r>
              <a:rPr lang="en-US" sz="900" b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figure S</a:t>
            </a:r>
            <a:r>
              <a:rPr lang="en-US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1</a:t>
            </a:r>
            <a:r>
              <a:rPr lang="en-US" sz="900" b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.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Replicate experiments for cell-cell fusion inhibition by recombinant antibodies. </a:t>
            </a:r>
            <a:r>
              <a:rPr lang="en-US" sz="900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One way </a:t>
            </a:r>
            <a:r>
              <a:rPr lang="en-US" sz="900" dirty="0" err="1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nnova</a:t>
            </a:r>
            <a:r>
              <a:rPr lang="en-US" sz="900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with </a:t>
            </a:r>
            <a:r>
              <a:rPr lang="en-US" sz="900" dirty="0" err="1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Geisser</a:t>
            </a:r>
            <a:r>
              <a:rPr lang="en-US" sz="900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Greenhouse corrections were performed for each experiment. All curves were statistically significant with P&lt;0.0001. Paired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 values of two tailed Student t test (P values) to compare DL11 (pink curves) and the combination of DL11 with each Mab (black curves) are indicated in each graph </a:t>
            </a:r>
            <a:endParaRPr lang="en-US" sz="900" dirty="0">
              <a:ln>
                <a:noFill/>
              </a:ln>
              <a:solidFill>
                <a:srgbClr val="000000"/>
              </a:solidFill>
              <a:effectLst/>
              <a:uFill>
                <a:solidFill>
                  <a:srgbClr val="000000"/>
                </a:solidFill>
              </a:uFill>
              <a:latin typeface="Palatino Linotype" panose="02040502050505030304" pitchFamily="18" charset="0"/>
              <a:ea typeface="Calibri" panose="020F0502020204030204" pitchFamily="34" charset="0"/>
            </a:endParaRPr>
          </a:p>
          <a:p>
            <a:endParaRPr lang="en-US" sz="900" dirty="0">
              <a:latin typeface="Palatino Linotype" panose="02040502050505030304" pitchFamily="18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F8A5809-0F08-4005-080C-BC0BD72A6A1F}"/>
              </a:ext>
            </a:extLst>
          </p:cNvPr>
          <p:cNvSpPr txBox="1"/>
          <p:nvPr/>
        </p:nvSpPr>
        <p:spPr>
          <a:xfrm>
            <a:off x="4587307" y="2064914"/>
            <a:ext cx="79220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Palatino Linotype" panose="02040502050505030304" pitchFamily="18" charset="0"/>
              </a:rPr>
              <a:t>P*** &lt;0.0001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CC64A1F-9FAC-3585-A6AA-FF63E9E815CD}"/>
              </a:ext>
            </a:extLst>
          </p:cNvPr>
          <p:cNvSpPr txBox="1"/>
          <p:nvPr/>
        </p:nvSpPr>
        <p:spPr>
          <a:xfrm>
            <a:off x="1868198" y="2064914"/>
            <a:ext cx="79220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Palatino Linotype" panose="02040502050505030304" pitchFamily="18" charset="0"/>
              </a:rPr>
              <a:t>P*** &lt;0.000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C3BCFC2-948A-ACCD-AA10-A17D223A6B7D}"/>
              </a:ext>
            </a:extLst>
          </p:cNvPr>
          <p:cNvSpPr txBox="1"/>
          <p:nvPr/>
        </p:nvSpPr>
        <p:spPr>
          <a:xfrm>
            <a:off x="4462691" y="6096000"/>
            <a:ext cx="7184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Palatino Linotype" panose="02040502050505030304" pitchFamily="18" charset="0"/>
              </a:rPr>
              <a:t>P**=0.0043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6445011-660D-DD4E-6C64-E0BD28A590B8}"/>
              </a:ext>
            </a:extLst>
          </p:cNvPr>
          <p:cNvSpPr txBox="1"/>
          <p:nvPr/>
        </p:nvSpPr>
        <p:spPr>
          <a:xfrm>
            <a:off x="1743582" y="6096000"/>
            <a:ext cx="79220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Palatino Linotype" panose="02040502050505030304" pitchFamily="18" charset="0"/>
              </a:rPr>
              <a:t>P*** &lt;0.0001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EE66A61-9DA0-F2DD-90F3-936432B56C91}"/>
              </a:ext>
            </a:extLst>
          </p:cNvPr>
          <p:cNvSpPr txBox="1"/>
          <p:nvPr/>
        </p:nvSpPr>
        <p:spPr>
          <a:xfrm>
            <a:off x="4953410" y="10127086"/>
            <a:ext cx="79220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Palatino Linotype" panose="02040502050505030304" pitchFamily="18" charset="0"/>
              </a:rPr>
              <a:t>P*** &lt;0.0001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A4037AD-AE5A-7AD5-8782-C1B2D6878811}"/>
              </a:ext>
            </a:extLst>
          </p:cNvPr>
          <p:cNvSpPr txBox="1"/>
          <p:nvPr/>
        </p:nvSpPr>
        <p:spPr>
          <a:xfrm>
            <a:off x="2139684" y="9999829"/>
            <a:ext cx="79220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Palatino Linotype" panose="02040502050505030304" pitchFamily="18" charset="0"/>
              </a:rPr>
              <a:t>P*** &lt;0.0001</a:t>
            </a:r>
          </a:p>
        </p:txBody>
      </p:sp>
    </p:spTree>
    <p:extLst>
      <p:ext uri="{BB962C8B-B14F-4D97-AF65-F5344CB8AC3E}">
        <p14:creationId xmlns:p14="http://schemas.microsoft.com/office/powerpoint/2010/main" val="272085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934</TotalTime>
  <Words>110</Words>
  <Application>Microsoft Office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Palatino Linotype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tanasiu, Doina</dc:creator>
  <cp:lastModifiedBy>Atanasiu, Doina</cp:lastModifiedBy>
  <cp:revision>7</cp:revision>
  <dcterms:created xsi:type="dcterms:W3CDTF">2025-01-27T19:04:54Z</dcterms:created>
  <dcterms:modified xsi:type="dcterms:W3CDTF">2025-01-31T17:17:19Z</dcterms:modified>
</cp:coreProperties>
</file>